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80" r:id="rId2"/>
    <p:sldId id="278" r:id="rId3"/>
    <p:sldId id="279" r:id="rId4"/>
    <p:sldId id="272" r:id="rId5"/>
    <p:sldId id="281" r:id="rId6"/>
    <p:sldId id="276" r:id="rId7"/>
    <p:sldId id="273" r:id="rId8"/>
  </p:sldIdLst>
  <p:sldSz cx="7561263" cy="10693400"/>
  <p:notesSz cx="6858000" cy="9144000"/>
  <p:defaultTextStyle>
    <a:defPPr>
      <a:defRPr lang="en-US"/>
    </a:defPPr>
    <a:lvl1pPr marL="0" algn="l" defTabSz="331166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1pPr>
    <a:lvl2pPr marL="331166" algn="l" defTabSz="331166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2pPr>
    <a:lvl3pPr marL="662333" algn="l" defTabSz="331166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3pPr>
    <a:lvl4pPr marL="993499" algn="l" defTabSz="331166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4pPr>
    <a:lvl5pPr marL="1324666" algn="l" defTabSz="331166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5pPr>
    <a:lvl6pPr marL="1655833" algn="l" defTabSz="331166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6pPr>
    <a:lvl7pPr marL="1987000" algn="l" defTabSz="331166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7pPr>
    <a:lvl8pPr marL="2318166" algn="l" defTabSz="331166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8pPr>
    <a:lvl9pPr marL="2649333" algn="l" defTabSz="331166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535" userDrawn="1">
          <p15:clr>
            <a:srgbClr val="A4A3A4"/>
          </p15:clr>
        </p15:guide>
        <p15:guide id="2" pos="3401" userDrawn="1">
          <p15:clr>
            <a:srgbClr val="A4A3A4"/>
          </p15:clr>
        </p15:guide>
        <p15:guide id="3" orient="horz" pos="3368">
          <p15:clr>
            <a:srgbClr val="A4A3A4"/>
          </p15:clr>
        </p15:guide>
        <p15:guide id="4" pos="238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50" d="100"/>
          <a:sy n="50" d="100"/>
        </p:scale>
        <p:origin x="488" y="-216"/>
      </p:cViewPr>
      <p:guideLst>
        <p:guide orient="horz" pos="4535"/>
        <p:guide pos="3401"/>
        <p:guide orient="horz" pos="3368"/>
        <p:guide pos="238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&#49345;&#50500;\&#45936;&#51060;&#53552;\QPCR\SRE10\admin_2018-03-31%20SiHa%20cis+RA%20-%20ULK1,%20ATG5,%20BECN1%20-%20%20Gene%20Expression%20Results%20-%20Bar%20Chart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&#49345;&#50500;\&#45936;&#51060;&#53552;\QPCR\SRE10\admin_2018-04-02%20SiHa%20cis+RA%20-%20Bax%20Noxa%20Puma%20-%20%20Gene%20Expression%20Results%20-%20Bar%20Chart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8.5604617102420205E-2"/>
          <c:y val="7.9927536231884061E-2"/>
          <c:w val="0.81575468133661799"/>
          <c:h val="0.73910704096770508"/>
        </c:manualLayout>
      </c:layout>
      <c:barChart>
        <c:barDir val="col"/>
        <c:grouping val="clustered"/>
        <c:varyColors val="0"/>
        <c:ser>
          <c:idx val="0"/>
          <c:order val="0"/>
          <c:tx>
            <c:v>Ctrl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'0'!$S$21,'0'!$S$27,'0'!$S$32,'0'!$S$39,'0'!$S$44,'0'!$S$50)</c:f>
                <c:numCache>
                  <c:formatCode>General</c:formatCode>
                  <c:ptCount val="6"/>
                  <c:pt idx="0">
                    <c:v>0.11933985964829399</c:v>
                  </c:pt>
                  <c:pt idx="1">
                    <c:v>1.9279700077975401E-2</c:v>
                  </c:pt>
                  <c:pt idx="2">
                    <c:v>4.3703006009780901E-2</c:v>
                  </c:pt>
                  <c:pt idx="3">
                    <c:v>8.5037404125118399E-2</c:v>
                  </c:pt>
                  <c:pt idx="4">
                    <c:v>0.102312817991092</c:v>
                  </c:pt>
                  <c:pt idx="5">
                    <c:v>8.2204679653651594E-2</c:v>
                  </c:pt>
                </c:numCache>
              </c:numRef>
            </c:plus>
            <c:minus>
              <c:numRef>
                <c:f>('0'!$S$21,'0'!$S$27,'0'!$S$32,'0'!$S$39,'0'!$S$44,'0'!$S$50)</c:f>
                <c:numCache>
                  <c:formatCode>General</c:formatCode>
                  <c:ptCount val="6"/>
                  <c:pt idx="0">
                    <c:v>0.11933985964829399</c:v>
                  </c:pt>
                  <c:pt idx="1">
                    <c:v>1.9279700077975401E-2</c:v>
                  </c:pt>
                  <c:pt idx="2">
                    <c:v>4.3703006009780901E-2</c:v>
                  </c:pt>
                  <c:pt idx="3">
                    <c:v>8.5037404125118399E-2</c:v>
                  </c:pt>
                  <c:pt idx="4">
                    <c:v>0.102312817991092</c:v>
                  </c:pt>
                  <c:pt idx="5">
                    <c:v>8.2204679653651594E-2</c:v>
                  </c:pt>
                </c:numCache>
              </c:numRef>
            </c:minus>
          </c:errBars>
          <c:cat>
            <c:strRef>
              <c:f>('0'!$C$20,'0'!$C$26,'0'!$C$32,'0'!$C$38,'0'!$C$44,'0'!$C$50)</c:f>
              <c:strCache>
                <c:ptCount val="6"/>
                <c:pt idx="0">
                  <c:v>ULK1</c:v>
                </c:pt>
                <c:pt idx="1">
                  <c:v>ATG5</c:v>
                </c:pt>
                <c:pt idx="2">
                  <c:v>BECN1</c:v>
                </c:pt>
                <c:pt idx="3">
                  <c:v>ATG7</c:v>
                </c:pt>
                <c:pt idx="4">
                  <c:v>ATG12</c:v>
                </c:pt>
                <c:pt idx="5">
                  <c:v>ATG13</c:v>
                </c:pt>
              </c:strCache>
            </c:strRef>
          </c:cat>
          <c:val>
            <c:numRef>
              <c:f>('0'!$P$21,'0'!$P$27,'0'!$P$32,'0'!$P$39,'0'!$P$44,'0'!$P$50)</c:f>
              <c:numCache>
                <c:formatCode>###0.00000;\-###0.00000</c:formatCode>
                <c:ptCount val="6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7FC-41F0-9E07-33B8271CDDA6}"/>
            </c:ext>
          </c:extLst>
        </c:ser>
        <c:ser>
          <c:idx val="1"/>
          <c:order val="1"/>
          <c:tx>
            <c:v>Cisplatin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'0'!$S$23,'0'!$S$29,'0'!$S$35,'0'!$S$40,'0'!$S$46,'0'!$S$53)</c:f>
                <c:numCache>
                  <c:formatCode>General</c:formatCode>
                  <c:ptCount val="6"/>
                  <c:pt idx="0">
                    <c:v>4.1474472620266302E-2</c:v>
                  </c:pt>
                  <c:pt idx="1">
                    <c:v>3.7482284639851503E-2</c:v>
                  </c:pt>
                  <c:pt idx="2">
                    <c:v>2.0643251403355E-2</c:v>
                  </c:pt>
                  <c:pt idx="3">
                    <c:v>0.18094435160222799</c:v>
                  </c:pt>
                  <c:pt idx="4">
                    <c:v>0.17453825354281299</c:v>
                  </c:pt>
                  <c:pt idx="5">
                    <c:v>0.20040660135178101</c:v>
                  </c:pt>
                </c:numCache>
              </c:numRef>
            </c:plus>
            <c:minus>
              <c:numRef>
                <c:f>('0'!$S$23,'0'!$S$29,'0'!$S$35,'0'!$S$40,'0'!$S$46,'0'!$S$53)</c:f>
                <c:numCache>
                  <c:formatCode>General</c:formatCode>
                  <c:ptCount val="6"/>
                  <c:pt idx="0">
                    <c:v>4.1474472620266302E-2</c:v>
                  </c:pt>
                  <c:pt idx="1">
                    <c:v>3.7482284639851503E-2</c:v>
                  </c:pt>
                  <c:pt idx="2">
                    <c:v>2.0643251403355E-2</c:v>
                  </c:pt>
                  <c:pt idx="3">
                    <c:v>0.18094435160222799</c:v>
                  </c:pt>
                  <c:pt idx="4">
                    <c:v>0.17453825354281299</c:v>
                  </c:pt>
                  <c:pt idx="5">
                    <c:v>0.20040660135178101</c:v>
                  </c:pt>
                </c:numCache>
              </c:numRef>
            </c:minus>
          </c:errBars>
          <c:cat>
            <c:strRef>
              <c:f>('0'!$C$20,'0'!$C$26,'0'!$C$32,'0'!$C$38,'0'!$C$44,'0'!$C$50)</c:f>
              <c:strCache>
                <c:ptCount val="6"/>
                <c:pt idx="0">
                  <c:v>ULK1</c:v>
                </c:pt>
                <c:pt idx="1">
                  <c:v>ATG5</c:v>
                </c:pt>
                <c:pt idx="2">
                  <c:v>BECN1</c:v>
                </c:pt>
                <c:pt idx="3">
                  <c:v>ATG7</c:v>
                </c:pt>
                <c:pt idx="4">
                  <c:v>ATG12</c:v>
                </c:pt>
                <c:pt idx="5">
                  <c:v>ATG13</c:v>
                </c:pt>
              </c:strCache>
            </c:strRef>
          </c:cat>
          <c:val>
            <c:numRef>
              <c:f>('0'!$P$23,'0'!$P$29,'0'!$P$35,'0'!$P$40,'0'!$P$46,'0'!$P$53)</c:f>
              <c:numCache>
                <c:formatCode>###0.00000;\-###0.00000</c:formatCode>
                <c:ptCount val="6"/>
                <c:pt idx="0">
                  <c:v>0.92456802724143095</c:v>
                </c:pt>
                <c:pt idx="1">
                  <c:v>1.1740115137829501</c:v>
                </c:pt>
                <c:pt idx="2">
                  <c:v>1.1611933163435599</c:v>
                </c:pt>
                <c:pt idx="3">
                  <c:v>1.8745365210914</c:v>
                </c:pt>
                <c:pt idx="4">
                  <c:v>1.62700634655772</c:v>
                </c:pt>
                <c:pt idx="5">
                  <c:v>1.5281603834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7FC-41F0-9E07-33B8271CDDA6}"/>
            </c:ext>
          </c:extLst>
        </c:ser>
        <c:ser>
          <c:idx val="3"/>
          <c:order val="2"/>
          <c:tx>
            <c:v>Cisplatin + RA</c:v>
          </c:tx>
          <c:spPr>
            <a:solidFill>
              <a:srgbClr val="C00000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'0'!$S$25,'0'!$S$31,'0'!$S$37,'0'!$S$42,'0'!$S$49,'0'!$S$55)</c:f>
                <c:numCache>
                  <c:formatCode>General</c:formatCode>
                  <c:ptCount val="6"/>
                  <c:pt idx="0">
                    <c:v>0.103831837175029</c:v>
                  </c:pt>
                  <c:pt idx="1">
                    <c:v>4.5752229534775E-2</c:v>
                  </c:pt>
                  <c:pt idx="2">
                    <c:v>3.99539076022941E-2</c:v>
                  </c:pt>
                  <c:pt idx="3">
                    <c:v>0.162252306598275</c:v>
                  </c:pt>
                  <c:pt idx="4">
                    <c:v>8.0220194074723597E-2</c:v>
                  </c:pt>
                  <c:pt idx="5">
                    <c:v>5.1464282012267999E-2</c:v>
                  </c:pt>
                </c:numCache>
              </c:numRef>
            </c:plus>
            <c:minus>
              <c:numRef>
                <c:f>('0'!$S$25,'0'!$S$31,'0'!$S$37,'0'!$S$42,'0'!$S$49,'0'!$S$55)</c:f>
                <c:numCache>
                  <c:formatCode>General</c:formatCode>
                  <c:ptCount val="6"/>
                  <c:pt idx="0">
                    <c:v>0.103831837175029</c:v>
                  </c:pt>
                  <c:pt idx="1">
                    <c:v>4.5752229534775E-2</c:v>
                  </c:pt>
                  <c:pt idx="2">
                    <c:v>3.99539076022941E-2</c:v>
                  </c:pt>
                  <c:pt idx="3">
                    <c:v>0.162252306598275</c:v>
                  </c:pt>
                  <c:pt idx="4">
                    <c:v>8.0220194074723597E-2</c:v>
                  </c:pt>
                  <c:pt idx="5">
                    <c:v>5.1464282012267999E-2</c:v>
                  </c:pt>
                </c:numCache>
              </c:numRef>
            </c:minus>
          </c:errBars>
          <c:cat>
            <c:strRef>
              <c:f>('0'!$C$20,'0'!$C$26,'0'!$C$32,'0'!$C$38,'0'!$C$44,'0'!$C$50)</c:f>
              <c:strCache>
                <c:ptCount val="6"/>
                <c:pt idx="0">
                  <c:v>ULK1</c:v>
                </c:pt>
                <c:pt idx="1">
                  <c:v>ATG5</c:v>
                </c:pt>
                <c:pt idx="2">
                  <c:v>BECN1</c:v>
                </c:pt>
                <c:pt idx="3">
                  <c:v>ATG7</c:v>
                </c:pt>
                <c:pt idx="4">
                  <c:v>ATG12</c:v>
                </c:pt>
                <c:pt idx="5">
                  <c:v>ATG13</c:v>
                </c:pt>
              </c:strCache>
            </c:strRef>
          </c:cat>
          <c:val>
            <c:numRef>
              <c:f>('0'!$P$25,'0'!$P$31,'0'!$P$37,'0'!$P$42,'0'!$P$49,'0'!$P$55)</c:f>
              <c:numCache>
                <c:formatCode>###0.00000;\-###0.00000</c:formatCode>
                <c:ptCount val="6"/>
                <c:pt idx="0">
                  <c:v>1.12837737201517</c:v>
                </c:pt>
                <c:pt idx="1">
                  <c:v>1.3546508803350299</c:v>
                </c:pt>
                <c:pt idx="2">
                  <c:v>1.1510499819995299</c:v>
                </c:pt>
                <c:pt idx="3">
                  <c:v>1.9834755963986801</c:v>
                </c:pt>
                <c:pt idx="4">
                  <c:v>2.08885359386688</c:v>
                </c:pt>
                <c:pt idx="5">
                  <c:v>1.72516044703277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7FC-41F0-9E07-33B8271CDDA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1130880"/>
        <c:axId val="171132416"/>
      </c:barChart>
      <c:catAx>
        <c:axId val="17113088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 i="1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defRPr>
            </a:pPr>
            <a:endParaRPr lang="ko-KR"/>
          </a:p>
        </c:txPr>
        <c:crossAx val="171132416"/>
        <c:crosses val="autoZero"/>
        <c:auto val="1"/>
        <c:lblAlgn val="ctr"/>
        <c:lblOffset val="100"/>
        <c:noMultiLvlLbl val="0"/>
      </c:catAx>
      <c:valAx>
        <c:axId val="171132416"/>
        <c:scaling>
          <c:orientation val="minMax"/>
        </c:scaling>
        <c:delete val="0"/>
        <c:axPos val="l"/>
        <c:numFmt formatCode="#,##0.0_);[Red]\(#,##0.0\)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defRPr>
            </a:pPr>
            <a:endParaRPr lang="ko-KR"/>
          </a:p>
        </c:txPr>
        <c:crossAx val="17113088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9.5550230134276687E-2"/>
          <c:y val="2.4247372372372372E-2"/>
          <c:w val="0.29252691239681994"/>
          <c:h val="0.17936373873873873"/>
        </c:manualLayout>
      </c:layout>
      <c:overlay val="0"/>
      <c:txPr>
        <a:bodyPr/>
        <a:lstStyle/>
        <a:p>
          <a:pPr>
            <a:defRPr sz="1200">
              <a:latin typeface="Arial" pitchFamily="34" charset="0"/>
              <a:ea typeface="Arial Unicode MS" pitchFamily="50" charset="-127"/>
              <a:cs typeface="Arial" pitchFamily="34" charset="0"/>
            </a:defRPr>
          </a:pPr>
          <a:endParaRPr lang="ko-KR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8.5604617102420205E-2"/>
          <c:y val="7.9927536231884061E-2"/>
          <c:w val="0.81575468133661799"/>
          <c:h val="0.73910704096770508"/>
        </c:manualLayout>
      </c:layout>
      <c:barChart>
        <c:barDir val="col"/>
        <c:grouping val="clustered"/>
        <c:varyColors val="0"/>
        <c:ser>
          <c:idx val="0"/>
          <c:order val="0"/>
          <c:tx>
            <c:v>Ctrl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'0'!$S$2,'0'!$S$14,'0'!$S$20,'0'!$S$26,'0'!$S$32,'0'!$S$38)</c:f>
                <c:numCache>
                  <c:formatCode>General</c:formatCode>
                  <c:ptCount val="6"/>
                  <c:pt idx="0">
                    <c:v>2.7471366112856398E-2</c:v>
                  </c:pt>
                  <c:pt idx="1">
                    <c:v>5.71079935032184E-2</c:v>
                  </c:pt>
                  <c:pt idx="2">
                    <c:v>0.20063262626824699</c:v>
                  </c:pt>
                  <c:pt idx="3">
                    <c:v>3.4264028453887901E-2</c:v>
                  </c:pt>
                  <c:pt idx="4">
                    <c:v>5.51950984881786E-2</c:v>
                  </c:pt>
                  <c:pt idx="5">
                    <c:v>5.4359118480268899E-2</c:v>
                  </c:pt>
                </c:numCache>
              </c:numRef>
            </c:plus>
            <c:minus>
              <c:numRef>
                <c:f>('0'!$S$2,'0'!$S$14,'0'!$S$20,'0'!$S$26,'0'!$S$32,'0'!$S$38)</c:f>
                <c:numCache>
                  <c:formatCode>General</c:formatCode>
                  <c:ptCount val="6"/>
                  <c:pt idx="0">
                    <c:v>2.7471366112856398E-2</c:v>
                  </c:pt>
                  <c:pt idx="1">
                    <c:v>5.71079935032184E-2</c:v>
                  </c:pt>
                  <c:pt idx="2">
                    <c:v>0.20063262626824699</c:v>
                  </c:pt>
                  <c:pt idx="3">
                    <c:v>3.4264028453887901E-2</c:v>
                  </c:pt>
                  <c:pt idx="4">
                    <c:v>5.51950984881786E-2</c:v>
                  </c:pt>
                  <c:pt idx="5">
                    <c:v>5.4359118480268899E-2</c:v>
                  </c:pt>
                </c:numCache>
              </c:numRef>
            </c:minus>
          </c:errBars>
          <c:cat>
            <c:strRef>
              <c:f>('C:\상아\데이터\QPCR\SRE10\[admin_2018-02-03 SiHa Cisplatin+SRE10 - Bax, Noxa, Puma -  Gene Expression Results - Bar Chart.xlsx]0'!$C$30,'C:\상아\데이터\QPCR\SRE10\[admin_2018-02-03 SiHa Cisplatin+SRE10 - Bax, Noxa, Puma -  Gene Expression Results - Bar Chart.xlsx]0'!$C$36,'C:\상아\데이터\QPCR\SRE10\[admin_2018-02-03 SiHa Cisplatin+SRE10 - Bax, Noxa, Puma -  Gene Expression Results - Bar Chart.xlsx]0'!$C$42,'C:\상아\데이터\QPCR\SRE10\[admin_2018-02-03 SiHa Cisplatin+SRE10 - Bax, Noxa, Puma -  Gene Expression Results - Bar Chart.xlsx]0'!$C$48,'C:\상아\데이터\QPCR\SRE10\[admin_2018-02-03 SiHa Cisplatin+SRE10 - Bax, Noxa, Puma -  Gene Expression Results - Bar Chart.xlsx]0'!$C$54,'C:\상아\데이터\QPCR\SRE10\[admin_2018-02-03 SiHa Cisplatin+SRE10 - Bax, Noxa, Puma -  Gene Expression Results - Bar Chart.xlsx]0'!$C$60)</c:f>
              <c:strCache>
                <c:ptCount val="6"/>
                <c:pt idx="0">
                  <c:v>Bax</c:v>
                </c:pt>
                <c:pt idx="1">
                  <c:v>Noxa</c:v>
                </c:pt>
                <c:pt idx="2">
                  <c:v>Puma</c:v>
                </c:pt>
                <c:pt idx="3">
                  <c:v>Gadd45α</c:v>
                </c:pt>
                <c:pt idx="4">
                  <c:v>p21</c:v>
                </c:pt>
                <c:pt idx="5">
                  <c:v>14-3-3σ</c:v>
                </c:pt>
              </c:strCache>
            </c:strRef>
          </c:cat>
          <c:val>
            <c:numRef>
              <c:f>('0'!$P$2,'0'!$P$14,'0'!$P$20,'0'!$P$26,'0'!$P$32,'0'!$P$38)</c:f>
              <c:numCache>
                <c:formatCode>###0.00000;\-###0.00000</c:formatCode>
                <c:ptCount val="6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221-4AF0-A72F-D7114DA834CB}"/>
            </c:ext>
          </c:extLst>
        </c:ser>
        <c:ser>
          <c:idx val="1"/>
          <c:order val="1"/>
          <c:tx>
            <c:v>Cisplatin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'0'!$S$5,'0'!$S$17,'0'!$S$22,'0'!$S$28,'0'!$S$34,'0'!$S$40)</c:f>
                <c:numCache>
                  <c:formatCode>General</c:formatCode>
                  <c:ptCount val="6"/>
                  <c:pt idx="0">
                    <c:v>0.13758231006072599</c:v>
                  </c:pt>
                  <c:pt idx="1">
                    <c:v>0.14730827706937899</c:v>
                  </c:pt>
                  <c:pt idx="2">
                    <c:v>0.52395872124541398</c:v>
                  </c:pt>
                  <c:pt idx="3">
                    <c:v>0.22283207515447001</c:v>
                  </c:pt>
                  <c:pt idx="4">
                    <c:v>0.18314651769627599</c:v>
                  </c:pt>
                  <c:pt idx="5">
                    <c:v>0.16987293276705401</c:v>
                  </c:pt>
                </c:numCache>
              </c:numRef>
            </c:plus>
            <c:minus>
              <c:numRef>
                <c:f>('0'!$S$5,'0'!$S$17,'0'!$S$22,'0'!$S$28,'0'!$S$34,'0'!$S$40)</c:f>
                <c:numCache>
                  <c:formatCode>General</c:formatCode>
                  <c:ptCount val="6"/>
                  <c:pt idx="0">
                    <c:v>0.13758231006072599</c:v>
                  </c:pt>
                  <c:pt idx="1">
                    <c:v>0.14730827706937899</c:v>
                  </c:pt>
                  <c:pt idx="2">
                    <c:v>0.52395872124541398</c:v>
                  </c:pt>
                  <c:pt idx="3">
                    <c:v>0.22283207515447001</c:v>
                  </c:pt>
                  <c:pt idx="4">
                    <c:v>0.18314651769627599</c:v>
                  </c:pt>
                  <c:pt idx="5">
                    <c:v>0.16987293276705401</c:v>
                  </c:pt>
                </c:numCache>
              </c:numRef>
            </c:minus>
          </c:errBars>
          <c:cat>
            <c:strRef>
              <c:f>('C:\상아\데이터\QPCR\SRE10\[admin_2018-02-03 SiHa Cisplatin+SRE10 - Bax, Noxa, Puma -  Gene Expression Results - Bar Chart.xlsx]0'!$C$30,'C:\상아\데이터\QPCR\SRE10\[admin_2018-02-03 SiHa Cisplatin+SRE10 - Bax, Noxa, Puma -  Gene Expression Results - Bar Chart.xlsx]0'!$C$36,'C:\상아\데이터\QPCR\SRE10\[admin_2018-02-03 SiHa Cisplatin+SRE10 - Bax, Noxa, Puma -  Gene Expression Results - Bar Chart.xlsx]0'!$C$42,'C:\상아\데이터\QPCR\SRE10\[admin_2018-02-03 SiHa Cisplatin+SRE10 - Bax, Noxa, Puma -  Gene Expression Results - Bar Chart.xlsx]0'!$C$48,'C:\상아\데이터\QPCR\SRE10\[admin_2018-02-03 SiHa Cisplatin+SRE10 - Bax, Noxa, Puma -  Gene Expression Results - Bar Chart.xlsx]0'!$C$54,'C:\상아\데이터\QPCR\SRE10\[admin_2018-02-03 SiHa Cisplatin+SRE10 - Bax, Noxa, Puma -  Gene Expression Results - Bar Chart.xlsx]0'!$C$60)</c:f>
              <c:strCache>
                <c:ptCount val="6"/>
                <c:pt idx="0">
                  <c:v>Bax</c:v>
                </c:pt>
                <c:pt idx="1">
                  <c:v>Noxa</c:v>
                </c:pt>
                <c:pt idx="2">
                  <c:v>Puma</c:v>
                </c:pt>
                <c:pt idx="3">
                  <c:v>Gadd45α</c:v>
                </c:pt>
                <c:pt idx="4">
                  <c:v>p21</c:v>
                </c:pt>
                <c:pt idx="5">
                  <c:v>14-3-3σ</c:v>
                </c:pt>
              </c:strCache>
            </c:strRef>
          </c:cat>
          <c:val>
            <c:numRef>
              <c:f>('0'!$P$5,'0'!$P$17,'0'!$P$22,'0'!$P$28,'0'!$P$34,'0'!$P$40)</c:f>
              <c:numCache>
                <c:formatCode>###0.00000;\-###0.00000</c:formatCode>
                <c:ptCount val="6"/>
                <c:pt idx="0">
                  <c:v>2.6159661194336601</c:v>
                </c:pt>
                <c:pt idx="1">
                  <c:v>2.8311663600301702</c:v>
                </c:pt>
                <c:pt idx="2">
                  <c:v>3.9159835835218</c:v>
                </c:pt>
                <c:pt idx="3">
                  <c:v>3.2217965620523898</c:v>
                </c:pt>
                <c:pt idx="4">
                  <c:v>2.7941450885991599</c:v>
                </c:pt>
                <c:pt idx="5">
                  <c:v>1.93215835345926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221-4AF0-A72F-D7114DA834CB}"/>
            </c:ext>
          </c:extLst>
        </c:ser>
        <c:ser>
          <c:idx val="3"/>
          <c:order val="2"/>
          <c:tx>
            <c:v>Cisplatin + RA</c:v>
          </c:tx>
          <c:spPr>
            <a:solidFill>
              <a:srgbClr val="C00000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'0'!$S$6,'0'!$S$18,'0'!$S$24,'0'!$S$30,'0'!$S$36,'0'!$S$42)</c:f>
                <c:numCache>
                  <c:formatCode>General</c:formatCode>
                  <c:ptCount val="6"/>
                  <c:pt idx="0">
                    <c:v>0.161871615819946</c:v>
                  </c:pt>
                  <c:pt idx="1">
                    <c:v>0.101527061080357</c:v>
                  </c:pt>
                  <c:pt idx="2">
                    <c:v>0.26178283104822497</c:v>
                  </c:pt>
                  <c:pt idx="3">
                    <c:v>0.43643168753987399</c:v>
                  </c:pt>
                  <c:pt idx="4">
                    <c:v>0.42814031204467601</c:v>
                  </c:pt>
                  <c:pt idx="5">
                    <c:v>0.27981184376899099</c:v>
                  </c:pt>
                </c:numCache>
              </c:numRef>
            </c:plus>
            <c:minus>
              <c:numRef>
                <c:f>('0'!$S$6,'0'!$S$18,'0'!$S$24,'0'!$S$30,'0'!$S$36,'0'!$S$42)</c:f>
                <c:numCache>
                  <c:formatCode>General</c:formatCode>
                  <c:ptCount val="6"/>
                  <c:pt idx="0">
                    <c:v>0.161871615819946</c:v>
                  </c:pt>
                  <c:pt idx="1">
                    <c:v>0.101527061080357</c:v>
                  </c:pt>
                  <c:pt idx="2">
                    <c:v>0.26178283104822497</c:v>
                  </c:pt>
                  <c:pt idx="3">
                    <c:v>0.43643168753987399</c:v>
                  </c:pt>
                  <c:pt idx="4">
                    <c:v>0.42814031204467601</c:v>
                  </c:pt>
                  <c:pt idx="5">
                    <c:v>0.27981184376899099</c:v>
                  </c:pt>
                </c:numCache>
              </c:numRef>
            </c:minus>
          </c:errBars>
          <c:cat>
            <c:strRef>
              <c:f>('C:\상아\데이터\QPCR\SRE10\[admin_2018-02-03 SiHa Cisplatin+SRE10 - Bax, Noxa, Puma -  Gene Expression Results - Bar Chart.xlsx]0'!$C$30,'C:\상아\데이터\QPCR\SRE10\[admin_2018-02-03 SiHa Cisplatin+SRE10 - Bax, Noxa, Puma -  Gene Expression Results - Bar Chart.xlsx]0'!$C$36,'C:\상아\데이터\QPCR\SRE10\[admin_2018-02-03 SiHa Cisplatin+SRE10 - Bax, Noxa, Puma -  Gene Expression Results - Bar Chart.xlsx]0'!$C$42,'C:\상아\데이터\QPCR\SRE10\[admin_2018-02-03 SiHa Cisplatin+SRE10 - Bax, Noxa, Puma -  Gene Expression Results - Bar Chart.xlsx]0'!$C$48,'C:\상아\데이터\QPCR\SRE10\[admin_2018-02-03 SiHa Cisplatin+SRE10 - Bax, Noxa, Puma -  Gene Expression Results - Bar Chart.xlsx]0'!$C$54,'C:\상아\데이터\QPCR\SRE10\[admin_2018-02-03 SiHa Cisplatin+SRE10 - Bax, Noxa, Puma -  Gene Expression Results - Bar Chart.xlsx]0'!$C$60)</c:f>
              <c:strCache>
                <c:ptCount val="6"/>
                <c:pt idx="0">
                  <c:v>Bax</c:v>
                </c:pt>
                <c:pt idx="1">
                  <c:v>Noxa</c:v>
                </c:pt>
                <c:pt idx="2">
                  <c:v>Puma</c:v>
                </c:pt>
                <c:pt idx="3">
                  <c:v>Gadd45α</c:v>
                </c:pt>
                <c:pt idx="4">
                  <c:v>p21</c:v>
                </c:pt>
                <c:pt idx="5">
                  <c:v>14-3-3σ</c:v>
                </c:pt>
              </c:strCache>
            </c:strRef>
          </c:cat>
          <c:val>
            <c:numRef>
              <c:f>('0'!$P$6,'0'!$P$18,'0'!$P$24,'0'!$P$30,'0'!$P$36,'0'!$P$42)</c:f>
              <c:numCache>
                <c:formatCode>###0.00000;\-###0.00000</c:formatCode>
                <c:ptCount val="6"/>
                <c:pt idx="0">
                  <c:v>3.0754518192770002</c:v>
                </c:pt>
                <c:pt idx="1">
                  <c:v>2.7343050501907298</c:v>
                </c:pt>
                <c:pt idx="2">
                  <c:v>3.5734411193850901</c:v>
                </c:pt>
                <c:pt idx="3">
                  <c:v>6.2397471674525997</c:v>
                </c:pt>
                <c:pt idx="4">
                  <c:v>8.3498189407844592</c:v>
                </c:pt>
                <c:pt idx="5">
                  <c:v>5.88207068691227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221-4AF0-A72F-D7114DA834C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3619072"/>
        <c:axId val="193620608"/>
      </c:barChart>
      <c:catAx>
        <c:axId val="19361907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 i="1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defRPr>
            </a:pPr>
            <a:endParaRPr lang="ko-KR"/>
          </a:p>
        </c:txPr>
        <c:crossAx val="193620608"/>
        <c:crosses val="autoZero"/>
        <c:auto val="1"/>
        <c:lblAlgn val="ctr"/>
        <c:lblOffset val="100"/>
        <c:noMultiLvlLbl val="0"/>
      </c:catAx>
      <c:valAx>
        <c:axId val="193620608"/>
        <c:scaling>
          <c:orientation val="minMax"/>
        </c:scaling>
        <c:delete val="0"/>
        <c:axPos val="l"/>
        <c:numFmt formatCode="#,##0_);[Red]\(#,##0\)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defRPr>
            </a:pPr>
            <a:endParaRPr lang="ko-KR"/>
          </a:p>
        </c:txPr>
        <c:crossAx val="19361907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0822975529745223"/>
          <c:y val="7.57136219216617E-2"/>
          <c:w val="0.2450305473524429"/>
          <c:h val="0.20267052469135802"/>
        </c:manualLayout>
      </c:layout>
      <c:overlay val="0"/>
      <c:txPr>
        <a:bodyPr/>
        <a:lstStyle/>
        <a:p>
          <a:pPr>
            <a:defRPr sz="1200">
              <a:latin typeface="Arial" pitchFamily="34" charset="0"/>
              <a:ea typeface="Arial Unicode MS" pitchFamily="50" charset="-127"/>
              <a:cs typeface="Arial" pitchFamily="34" charset="0"/>
            </a:defRPr>
          </a:pPr>
          <a:endParaRPr lang="ko-KR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7095" y="1750056"/>
            <a:ext cx="6427074" cy="3722887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5158" y="5616511"/>
            <a:ext cx="5670947" cy="2581762"/>
          </a:xfrm>
        </p:spPr>
        <p:txBody>
          <a:bodyPr/>
          <a:lstStyle>
            <a:lvl1pPr marL="0" indent="0" algn="ctr">
              <a:buNone/>
              <a:defRPr sz="2100"/>
            </a:lvl1pPr>
            <a:lvl2pPr marL="391141" indent="0" algn="ctr">
              <a:buNone/>
              <a:defRPr sz="1700"/>
            </a:lvl2pPr>
            <a:lvl3pPr marL="782282" indent="0" algn="ctr">
              <a:buNone/>
              <a:defRPr sz="1500"/>
            </a:lvl3pPr>
            <a:lvl4pPr marL="1173423" indent="0" algn="ctr">
              <a:buNone/>
              <a:defRPr sz="1400"/>
            </a:lvl4pPr>
            <a:lvl5pPr marL="1564563" indent="0" algn="ctr">
              <a:buNone/>
              <a:defRPr sz="1400"/>
            </a:lvl5pPr>
            <a:lvl6pPr marL="1955705" indent="0" algn="ctr">
              <a:buNone/>
              <a:defRPr sz="1400"/>
            </a:lvl6pPr>
            <a:lvl7pPr marL="2346845" indent="0" algn="ctr">
              <a:buNone/>
              <a:defRPr sz="1400"/>
            </a:lvl7pPr>
            <a:lvl8pPr marL="2737986" indent="0" algn="ctr">
              <a:buNone/>
              <a:defRPr sz="1400"/>
            </a:lvl8pPr>
            <a:lvl9pPr marL="3129126" indent="0" algn="ctr">
              <a:buNone/>
              <a:defRPr sz="14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471D09-913B-4B5D-975C-3B7C994B7520}" type="datetimeFigureOut">
              <a:rPr lang="ko-KR" altLang="en-US" smtClean="0"/>
              <a:t>2019-05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448AA-3969-4E03-8ADB-95A25054BE6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364621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471D09-913B-4B5D-975C-3B7C994B7520}" type="datetimeFigureOut">
              <a:rPr lang="ko-KR" altLang="en-US" smtClean="0"/>
              <a:t>2019-05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448AA-3969-4E03-8ADB-95A25054BE6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847207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11030" y="569325"/>
            <a:ext cx="1630397" cy="9062162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838" y="569325"/>
            <a:ext cx="4796676" cy="9062162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471D09-913B-4B5D-975C-3B7C994B7520}" type="datetimeFigureOut">
              <a:rPr lang="ko-KR" altLang="en-US" smtClean="0"/>
              <a:t>2019-05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448AA-3969-4E03-8ADB-95A25054BE6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028142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471D09-913B-4B5D-975C-3B7C994B7520}" type="datetimeFigureOut">
              <a:rPr lang="ko-KR" altLang="en-US" smtClean="0"/>
              <a:t>2019-05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448AA-3969-4E03-8ADB-95A25054BE6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138989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900" y="2665928"/>
            <a:ext cx="6521589" cy="4448156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900" y="7156165"/>
            <a:ext cx="6521589" cy="2339181"/>
          </a:xfrm>
        </p:spPr>
        <p:txBody>
          <a:bodyPr/>
          <a:lstStyle>
            <a:lvl1pPr marL="0" indent="0">
              <a:buNone/>
              <a:defRPr sz="2100">
                <a:solidFill>
                  <a:schemeClr val="tx1"/>
                </a:solidFill>
              </a:defRPr>
            </a:lvl1pPr>
            <a:lvl2pPr marL="391141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82282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3pPr>
            <a:lvl4pPr marL="117342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56456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1955705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346845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273798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12912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471D09-913B-4B5D-975C-3B7C994B7520}" type="datetimeFigureOut">
              <a:rPr lang="ko-KR" altLang="en-US" smtClean="0"/>
              <a:t>2019-05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448AA-3969-4E03-8ADB-95A25054BE6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585491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837" y="2846623"/>
            <a:ext cx="3213537" cy="678486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890" y="2846623"/>
            <a:ext cx="3213537" cy="678486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471D09-913B-4B5D-975C-3B7C994B7520}" type="datetimeFigureOut">
              <a:rPr lang="ko-KR" altLang="en-US" smtClean="0"/>
              <a:t>2019-05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448AA-3969-4E03-8ADB-95A25054BE6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312453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823" y="569327"/>
            <a:ext cx="6521589" cy="2066896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824" y="2621370"/>
            <a:ext cx="3198768" cy="1284692"/>
          </a:xfrm>
        </p:spPr>
        <p:txBody>
          <a:bodyPr anchor="b"/>
          <a:lstStyle>
            <a:lvl1pPr marL="0" indent="0">
              <a:buNone/>
              <a:defRPr sz="2100" b="1"/>
            </a:lvl1pPr>
            <a:lvl2pPr marL="391141" indent="0">
              <a:buNone/>
              <a:defRPr sz="1700" b="1"/>
            </a:lvl2pPr>
            <a:lvl3pPr marL="782282" indent="0">
              <a:buNone/>
              <a:defRPr sz="1500" b="1"/>
            </a:lvl3pPr>
            <a:lvl4pPr marL="1173423" indent="0">
              <a:buNone/>
              <a:defRPr sz="1400" b="1"/>
            </a:lvl4pPr>
            <a:lvl5pPr marL="1564563" indent="0">
              <a:buNone/>
              <a:defRPr sz="1400" b="1"/>
            </a:lvl5pPr>
            <a:lvl6pPr marL="1955705" indent="0">
              <a:buNone/>
              <a:defRPr sz="1400" b="1"/>
            </a:lvl6pPr>
            <a:lvl7pPr marL="2346845" indent="0">
              <a:buNone/>
              <a:defRPr sz="1400" b="1"/>
            </a:lvl7pPr>
            <a:lvl8pPr marL="2737986" indent="0">
              <a:buNone/>
              <a:defRPr sz="1400" b="1"/>
            </a:lvl8pPr>
            <a:lvl9pPr marL="3129126" indent="0">
              <a:buNone/>
              <a:defRPr sz="14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824" y="3906062"/>
            <a:ext cx="3198768" cy="574522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891" y="2621370"/>
            <a:ext cx="3214521" cy="1284692"/>
          </a:xfrm>
        </p:spPr>
        <p:txBody>
          <a:bodyPr anchor="b"/>
          <a:lstStyle>
            <a:lvl1pPr marL="0" indent="0">
              <a:buNone/>
              <a:defRPr sz="2100" b="1"/>
            </a:lvl1pPr>
            <a:lvl2pPr marL="391141" indent="0">
              <a:buNone/>
              <a:defRPr sz="1700" b="1"/>
            </a:lvl2pPr>
            <a:lvl3pPr marL="782282" indent="0">
              <a:buNone/>
              <a:defRPr sz="1500" b="1"/>
            </a:lvl3pPr>
            <a:lvl4pPr marL="1173423" indent="0">
              <a:buNone/>
              <a:defRPr sz="1400" b="1"/>
            </a:lvl4pPr>
            <a:lvl5pPr marL="1564563" indent="0">
              <a:buNone/>
              <a:defRPr sz="1400" b="1"/>
            </a:lvl5pPr>
            <a:lvl6pPr marL="1955705" indent="0">
              <a:buNone/>
              <a:defRPr sz="1400" b="1"/>
            </a:lvl6pPr>
            <a:lvl7pPr marL="2346845" indent="0">
              <a:buNone/>
              <a:defRPr sz="1400" b="1"/>
            </a:lvl7pPr>
            <a:lvl8pPr marL="2737986" indent="0">
              <a:buNone/>
              <a:defRPr sz="1400" b="1"/>
            </a:lvl8pPr>
            <a:lvl9pPr marL="3129126" indent="0">
              <a:buNone/>
              <a:defRPr sz="14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891" y="3906062"/>
            <a:ext cx="3214521" cy="574522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471D09-913B-4B5D-975C-3B7C994B7520}" type="datetimeFigureOut">
              <a:rPr lang="ko-KR" altLang="en-US" smtClean="0"/>
              <a:t>2019-05-26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448AA-3969-4E03-8ADB-95A25054BE6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902547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471D09-913B-4B5D-975C-3B7C994B7520}" type="datetimeFigureOut">
              <a:rPr lang="ko-KR" altLang="en-US" smtClean="0"/>
              <a:t>2019-05-26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448AA-3969-4E03-8ADB-95A25054BE6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894264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471D09-913B-4B5D-975C-3B7C994B7520}" type="datetimeFigureOut">
              <a:rPr lang="ko-KR" altLang="en-US" smtClean="0"/>
              <a:t>2019-05-26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448AA-3969-4E03-8ADB-95A25054BE6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865159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822" y="712893"/>
            <a:ext cx="2438705" cy="2495127"/>
          </a:xfrm>
        </p:spPr>
        <p:txBody>
          <a:bodyPr anchor="b"/>
          <a:lstStyle>
            <a:lvl1pPr>
              <a:defRPr sz="27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4522" y="1539655"/>
            <a:ext cx="3827889" cy="7599245"/>
          </a:xfrm>
        </p:spPr>
        <p:txBody>
          <a:bodyPr/>
          <a:lstStyle>
            <a:lvl1pPr>
              <a:defRPr sz="2700"/>
            </a:lvl1pPr>
            <a:lvl2pPr>
              <a:defRPr sz="2400"/>
            </a:lvl2pPr>
            <a:lvl3pPr>
              <a:defRPr sz="21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822" y="3208021"/>
            <a:ext cx="2438705" cy="5943254"/>
          </a:xfrm>
        </p:spPr>
        <p:txBody>
          <a:bodyPr/>
          <a:lstStyle>
            <a:lvl1pPr marL="0" indent="0">
              <a:buNone/>
              <a:defRPr sz="1400"/>
            </a:lvl1pPr>
            <a:lvl2pPr marL="391141" indent="0">
              <a:buNone/>
              <a:defRPr sz="1200"/>
            </a:lvl2pPr>
            <a:lvl3pPr marL="782282" indent="0">
              <a:buNone/>
              <a:defRPr sz="1000"/>
            </a:lvl3pPr>
            <a:lvl4pPr marL="1173423" indent="0">
              <a:buNone/>
              <a:defRPr sz="900"/>
            </a:lvl4pPr>
            <a:lvl5pPr marL="1564563" indent="0">
              <a:buNone/>
              <a:defRPr sz="900"/>
            </a:lvl5pPr>
            <a:lvl6pPr marL="1955705" indent="0">
              <a:buNone/>
              <a:defRPr sz="900"/>
            </a:lvl6pPr>
            <a:lvl7pPr marL="2346845" indent="0">
              <a:buNone/>
              <a:defRPr sz="900"/>
            </a:lvl7pPr>
            <a:lvl8pPr marL="2737986" indent="0">
              <a:buNone/>
              <a:defRPr sz="900"/>
            </a:lvl8pPr>
            <a:lvl9pPr marL="3129126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471D09-913B-4B5D-975C-3B7C994B7520}" type="datetimeFigureOut">
              <a:rPr lang="ko-KR" altLang="en-US" smtClean="0"/>
              <a:t>2019-05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448AA-3969-4E03-8ADB-95A25054BE6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522000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822" y="712893"/>
            <a:ext cx="2438705" cy="2495127"/>
          </a:xfrm>
        </p:spPr>
        <p:txBody>
          <a:bodyPr anchor="b"/>
          <a:lstStyle>
            <a:lvl1pPr>
              <a:defRPr sz="27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4522" y="1539655"/>
            <a:ext cx="3827889" cy="7599245"/>
          </a:xfrm>
        </p:spPr>
        <p:txBody>
          <a:bodyPr anchor="t"/>
          <a:lstStyle>
            <a:lvl1pPr marL="0" indent="0">
              <a:buNone/>
              <a:defRPr sz="2700"/>
            </a:lvl1pPr>
            <a:lvl2pPr marL="391141" indent="0">
              <a:buNone/>
              <a:defRPr sz="2400"/>
            </a:lvl2pPr>
            <a:lvl3pPr marL="782282" indent="0">
              <a:buNone/>
              <a:defRPr sz="2100"/>
            </a:lvl3pPr>
            <a:lvl4pPr marL="1173423" indent="0">
              <a:buNone/>
              <a:defRPr sz="1700"/>
            </a:lvl4pPr>
            <a:lvl5pPr marL="1564563" indent="0">
              <a:buNone/>
              <a:defRPr sz="1700"/>
            </a:lvl5pPr>
            <a:lvl6pPr marL="1955705" indent="0">
              <a:buNone/>
              <a:defRPr sz="1700"/>
            </a:lvl6pPr>
            <a:lvl7pPr marL="2346845" indent="0">
              <a:buNone/>
              <a:defRPr sz="1700"/>
            </a:lvl7pPr>
            <a:lvl8pPr marL="2737986" indent="0">
              <a:buNone/>
              <a:defRPr sz="1700"/>
            </a:lvl8pPr>
            <a:lvl9pPr marL="3129126" indent="0">
              <a:buNone/>
              <a:defRPr sz="17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822" y="3208021"/>
            <a:ext cx="2438705" cy="5943254"/>
          </a:xfrm>
        </p:spPr>
        <p:txBody>
          <a:bodyPr/>
          <a:lstStyle>
            <a:lvl1pPr marL="0" indent="0">
              <a:buNone/>
              <a:defRPr sz="1400"/>
            </a:lvl1pPr>
            <a:lvl2pPr marL="391141" indent="0">
              <a:buNone/>
              <a:defRPr sz="1200"/>
            </a:lvl2pPr>
            <a:lvl3pPr marL="782282" indent="0">
              <a:buNone/>
              <a:defRPr sz="1000"/>
            </a:lvl3pPr>
            <a:lvl4pPr marL="1173423" indent="0">
              <a:buNone/>
              <a:defRPr sz="900"/>
            </a:lvl4pPr>
            <a:lvl5pPr marL="1564563" indent="0">
              <a:buNone/>
              <a:defRPr sz="900"/>
            </a:lvl5pPr>
            <a:lvl6pPr marL="1955705" indent="0">
              <a:buNone/>
              <a:defRPr sz="900"/>
            </a:lvl6pPr>
            <a:lvl7pPr marL="2346845" indent="0">
              <a:buNone/>
              <a:defRPr sz="900"/>
            </a:lvl7pPr>
            <a:lvl8pPr marL="2737986" indent="0">
              <a:buNone/>
              <a:defRPr sz="900"/>
            </a:lvl8pPr>
            <a:lvl9pPr marL="3129126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471D09-913B-4B5D-975C-3B7C994B7520}" type="datetimeFigureOut">
              <a:rPr lang="ko-KR" altLang="en-US" smtClean="0"/>
              <a:t>2019-05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448AA-3969-4E03-8ADB-95A25054BE6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777572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838" y="569327"/>
            <a:ext cx="6521589" cy="2066896"/>
          </a:xfrm>
          <a:prstGeom prst="rect">
            <a:avLst/>
          </a:prstGeom>
        </p:spPr>
        <p:txBody>
          <a:bodyPr vert="horz" lIns="66233" tIns="33117" rIns="66233" bIns="33117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838" y="2846623"/>
            <a:ext cx="6521589" cy="6784864"/>
          </a:xfrm>
          <a:prstGeom prst="rect">
            <a:avLst/>
          </a:prstGeom>
        </p:spPr>
        <p:txBody>
          <a:bodyPr vert="horz" lIns="66233" tIns="33117" rIns="66233" bIns="33117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837" y="9911200"/>
            <a:ext cx="1701284" cy="569325"/>
          </a:xfrm>
          <a:prstGeom prst="rect">
            <a:avLst/>
          </a:prstGeom>
        </p:spPr>
        <p:txBody>
          <a:bodyPr vert="horz" lIns="66233" tIns="33117" rIns="66233" bIns="33117" rtlCol="0" anchor="ctr"/>
          <a:lstStyle>
            <a:lvl1pPr algn="l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471D09-913B-4B5D-975C-3B7C994B7520}" type="datetimeFigureOut">
              <a:rPr lang="ko-KR" altLang="en-US" smtClean="0"/>
              <a:t>2019-05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670" y="9911200"/>
            <a:ext cx="2551926" cy="569325"/>
          </a:xfrm>
          <a:prstGeom prst="rect">
            <a:avLst/>
          </a:prstGeom>
        </p:spPr>
        <p:txBody>
          <a:bodyPr vert="horz" lIns="66233" tIns="33117" rIns="66233" bIns="33117" rtlCol="0" anchor="ctr"/>
          <a:lstStyle>
            <a:lvl1pPr algn="ct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40143" y="9911200"/>
            <a:ext cx="1701284" cy="569325"/>
          </a:xfrm>
          <a:prstGeom prst="rect">
            <a:avLst/>
          </a:prstGeom>
        </p:spPr>
        <p:txBody>
          <a:bodyPr vert="horz" lIns="66233" tIns="33117" rIns="66233" bIns="33117" rtlCol="0" anchor="ctr"/>
          <a:lstStyle>
            <a:lvl1pPr algn="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7448AA-3969-4E03-8ADB-95A25054BE6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27283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782282" rtl="0" eaLnBrk="1" latinLnBrk="1" hangingPunct="1">
        <a:lnSpc>
          <a:spcPct val="90000"/>
        </a:lnSpc>
        <a:spcBef>
          <a:spcPct val="0"/>
        </a:spcBef>
        <a:buNone/>
        <a:defRPr sz="38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5570" indent="-195570" algn="l" defTabSz="782282" rtl="0" eaLnBrk="1" latinLnBrk="1" hangingPunct="1">
        <a:lnSpc>
          <a:spcPct val="90000"/>
        </a:lnSpc>
        <a:spcBef>
          <a:spcPts val="856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86711" indent="-195570" algn="l" defTabSz="782282" rtl="0" eaLnBrk="1" latinLnBrk="1" hangingPunct="1">
        <a:lnSpc>
          <a:spcPct val="90000"/>
        </a:lnSpc>
        <a:spcBef>
          <a:spcPts val="428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977852" indent="-195570" algn="l" defTabSz="782282" rtl="0" eaLnBrk="1" latinLnBrk="1" hangingPunct="1">
        <a:lnSpc>
          <a:spcPct val="90000"/>
        </a:lnSpc>
        <a:spcBef>
          <a:spcPts val="428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8992" indent="-195570" algn="l" defTabSz="782282" rtl="0" eaLnBrk="1" latinLnBrk="1" hangingPunct="1">
        <a:lnSpc>
          <a:spcPct val="90000"/>
        </a:lnSpc>
        <a:spcBef>
          <a:spcPts val="428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760134" indent="-195570" algn="l" defTabSz="782282" rtl="0" eaLnBrk="1" latinLnBrk="1" hangingPunct="1">
        <a:lnSpc>
          <a:spcPct val="90000"/>
        </a:lnSpc>
        <a:spcBef>
          <a:spcPts val="428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2151274" indent="-195570" algn="l" defTabSz="782282" rtl="0" eaLnBrk="1" latinLnBrk="1" hangingPunct="1">
        <a:lnSpc>
          <a:spcPct val="90000"/>
        </a:lnSpc>
        <a:spcBef>
          <a:spcPts val="428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542415" indent="-195570" algn="l" defTabSz="782282" rtl="0" eaLnBrk="1" latinLnBrk="1" hangingPunct="1">
        <a:lnSpc>
          <a:spcPct val="90000"/>
        </a:lnSpc>
        <a:spcBef>
          <a:spcPts val="428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933556" indent="-195570" algn="l" defTabSz="782282" rtl="0" eaLnBrk="1" latinLnBrk="1" hangingPunct="1">
        <a:lnSpc>
          <a:spcPct val="90000"/>
        </a:lnSpc>
        <a:spcBef>
          <a:spcPts val="428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3324697" indent="-195570" algn="l" defTabSz="782282" rtl="0" eaLnBrk="1" latinLnBrk="1" hangingPunct="1">
        <a:lnSpc>
          <a:spcPct val="90000"/>
        </a:lnSpc>
        <a:spcBef>
          <a:spcPts val="428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82282" rtl="0" eaLnBrk="1" latinLnBrk="1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1pPr>
      <a:lvl2pPr marL="391141" algn="l" defTabSz="782282" rtl="0" eaLnBrk="1" latinLnBrk="1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2pPr>
      <a:lvl3pPr marL="782282" algn="l" defTabSz="782282" rtl="0" eaLnBrk="1" latinLnBrk="1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173423" algn="l" defTabSz="782282" rtl="0" eaLnBrk="1" latinLnBrk="1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64563" algn="l" defTabSz="782282" rtl="0" eaLnBrk="1" latinLnBrk="1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955705" algn="l" defTabSz="782282" rtl="0" eaLnBrk="1" latinLnBrk="1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346845" algn="l" defTabSz="782282" rtl="0" eaLnBrk="1" latinLnBrk="1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737986" algn="l" defTabSz="782282" rtl="0" eaLnBrk="1" latinLnBrk="1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3129126" algn="l" defTabSz="782282" rtl="0" eaLnBrk="1" latinLnBrk="1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microsoft.com/office/2007/relationships/hdphoto" Target="../media/hdphoto2.wdp"/><Relationship Id="rId4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microsoft.com/office/2007/relationships/hdphoto" Target="../media/hdphoto9.wdp"/><Relationship Id="rId18" Type="http://schemas.openxmlformats.org/officeDocument/2006/relationships/image" Target="../media/image13.png"/><Relationship Id="rId3" Type="http://schemas.microsoft.com/office/2007/relationships/hdphoto" Target="../media/hdphoto4.wdp"/><Relationship Id="rId21" Type="http://schemas.microsoft.com/office/2007/relationships/hdphoto" Target="../media/hdphoto13.wdp"/><Relationship Id="rId7" Type="http://schemas.microsoft.com/office/2007/relationships/hdphoto" Target="../media/hdphoto6.wdp"/><Relationship Id="rId12" Type="http://schemas.openxmlformats.org/officeDocument/2006/relationships/image" Target="../media/image10.png"/><Relationship Id="rId17" Type="http://schemas.microsoft.com/office/2007/relationships/hdphoto" Target="../media/hdphoto11.wdp"/><Relationship Id="rId2" Type="http://schemas.openxmlformats.org/officeDocument/2006/relationships/image" Target="../media/image5.png"/><Relationship Id="rId16" Type="http://schemas.openxmlformats.org/officeDocument/2006/relationships/image" Target="../media/image12.png"/><Relationship Id="rId20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11" Type="http://schemas.microsoft.com/office/2007/relationships/hdphoto" Target="../media/hdphoto8.wdp"/><Relationship Id="rId5" Type="http://schemas.microsoft.com/office/2007/relationships/hdphoto" Target="../media/hdphoto5.wdp"/><Relationship Id="rId15" Type="http://schemas.microsoft.com/office/2007/relationships/hdphoto" Target="../media/hdphoto10.wdp"/><Relationship Id="rId10" Type="http://schemas.openxmlformats.org/officeDocument/2006/relationships/image" Target="../media/image9.png"/><Relationship Id="rId19" Type="http://schemas.microsoft.com/office/2007/relationships/hdphoto" Target="../media/hdphoto12.wdp"/><Relationship Id="rId4" Type="http://schemas.openxmlformats.org/officeDocument/2006/relationships/image" Target="../media/image6.png"/><Relationship Id="rId9" Type="http://schemas.microsoft.com/office/2007/relationships/hdphoto" Target="../media/hdphoto7.wdp"/><Relationship Id="rId14" Type="http://schemas.openxmlformats.org/officeDocument/2006/relationships/image" Target="../media/image11.png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14.wdp"/><Relationship Id="rId7" Type="http://schemas.microsoft.com/office/2007/relationships/hdphoto" Target="../media/hdphoto16.wdp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png"/><Relationship Id="rId5" Type="http://schemas.microsoft.com/office/2007/relationships/hdphoto" Target="../media/hdphoto15.wdp"/><Relationship Id="rId4" Type="http://schemas.openxmlformats.org/officeDocument/2006/relationships/image" Target="../media/image16.png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hdphoto" Target="../media/hdphoto17.wdp"/><Relationship Id="rId7" Type="http://schemas.openxmlformats.org/officeDocument/2006/relationships/image" Target="../media/image21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png"/><Relationship Id="rId5" Type="http://schemas.microsoft.com/office/2007/relationships/hdphoto" Target="../media/hdphoto18.wdp"/><Relationship Id="rId4" Type="http://schemas.openxmlformats.org/officeDocument/2006/relationships/image" Target="../media/image19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/>
          <p:cNvSpPr/>
          <p:nvPr/>
        </p:nvSpPr>
        <p:spPr>
          <a:xfrm>
            <a:off x="876300" y="1573570"/>
            <a:ext cx="5714999" cy="51346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GB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Data</a:t>
            </a:r>
          </a:p>
          <a:p>
            <a:pPr>
              <a:lnSpc>
                <a:spcPct val="150000"/>
              </a:lnSpc>
            </a:pPr>
            <a:endParaRPr lang="en-GB" altLang="ko-KR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GB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dentification of a novel S6K1 inhibitor, </a:t>
            </a:r>
            <a:r>
              <a:rPr lang="en-GB" altLang="ko-KR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osmarinic</a:t>
            </a:r>
            <a:r>
              <a:rPr lang="en-GB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id methyl ester, for treating cisplatin-resistant cervical cancer</a:t>
            </a:r>
            <a:endParaRPr lang="ko-KR" altLang="ko-KR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GB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</a:p>
          <a:p>
            <a:pPr>
              <a:lnSpc>
                <a:spcPct val="150000"/>
              </a:lnSpc>
            </a:pPr>
            <a:endParaRPr lang="ko-KR" altLang="ko-K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 Hong Nam</a:t>
            </a:r>
            <a:r>
              <a:rPr lang="en-GB" altLang="ko-KR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Sang Ah Yi</a:t>
            </a:r>
            <a:r>
              <a:rPr lang="en-GB" altLang="ko-KR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ibeom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am</a:t>
            </a:r>
            <a:r>
              <a:rPr lang="en-GB" altLang="ko-KR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Jae Sung Noh</a:t>
            </a:r>
            <a:r>
              <a:rPr lang="en-GB" altLang="ko-KR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Jong Woo Park</a:t>
            </a:r>
            <a:r>
              <a:rPr lang="en-GB" altLang="ko-KR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in </a:t>
            </a:r>
            <a:r>
              <a:rPr lang="en-GB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yu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ee</a:t>
            </a:r>
            <a:r>
              <a:rPr lang="en-GB" altLang="ko-KR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ee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un Park</a:t>
            </a:r>
            <a:r>
              <a:rPr lang="en-GB" altLang="ko-KR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wamok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h</a:t>
            </a:r>
            <a:r>
              <a:rPr lang="en-GB" altLang="ko-KR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ieun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ee</a:t>
            </a:r>
            <a:r>
              <a:rPr lang="en-GB" altLang="ko-KR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Kang Ro </a:t>
            </a:r>
            <a:r>
              <a:rPr lang="en-GB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e</a:t>
            </a:r>
            <a:r>
              <a:rPr lang="en-GB" altLang="ko-KR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Hyun-Ju Park</a:t>
            </a:r>
            <a:r>
              <a:rPr lang="en-GB" altLang="ko-KR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aecheol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ee</a:t>
            </a:r>
            <a:r>
              <a:rPr lang="en-GB" altLang="ko-KR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</a:t>
            </a:r>
            <a:r>
              <a:rPr lang="en-GB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eung-Whan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an</a:t>
            </a:r>
            <a:r>
              <a:rPr lang="en-GB" altLang="ko-KR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ko-KR" altLang="ko-K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endParaRPr lang="en-GB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GB" altLang="ko-KR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hool of Pharmacy, </a:t>
            </a:r>
            <a:r>
              <a:rPr lang="en-GB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ngkyunkwan</a:t>
            </a:r>
            <a:r>
              <a: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University, Suwon 16419, Republic of Korea</a:t>
            </a:r>
          </a:p>
          <a:p>
            <a:pPr>
              <a:lnSpc>
                <a:spcPct val="150000"/>
              </a:lnSpc>
            </a:pPr>
            <a:endParaRPr lang="en-GB" altLang="ko-K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 Hong Nam and Sang Ah Yi contributed equally to this work.</a:t>
            </a:r>
          </a:p>
          <a:p>
            <a:pPr>
              <a:lnSpc>
                <a:spcPct val="150000"/>
              </a:lnSpc>
            </a:pPr>
            <a:endParaRPr lang="en-US" altLang="ko-K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spondence to </a:t>
            </a:r>
            <a:r>
              <a:rPr lang="en-US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eung-Whan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an (e-mail: jhhan551@skku.edu; Telephone: +82-10-2760-7716)</a:t>
            </a:r>
          </a:p>
        </p:txBody>
      </p:sp>
    </p:spTree>
    <p:extLst>
      <p:ext uri="{BB962C8B-B14F-4D97-AF65-F5344CB8AC3E}">
        <p14:creationId xmlns:p14="http://schemas.microsoft.com/office/powerpoint/2010/main" val="7367066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직사각형 4">
            <a:extLst>
              <a:ext uri="{FF2B5EF4-FFF2-40B4-BE49-F238E27FC236}">
                <a16:creationId xmlns:a16="http://schemas.microsoft.com/office/drawing/2014/main" id="{9288D8D2-2C25-4E6B-9864-53E61EC5DE04}"/>
              </a:ext>
            </a:extLst>
          </p:cNvPr>
          <p:cNvSpPr/>
          <p:nvPr/>
        </p:nvSpPr>
        <p:spPr>
          <a:xfrm>
            <a:off x="819066" y="5769321"/>
            <a:ext cx="5923126" cy="446139"/>
          </a:xfrm>
          <a:prstGeom prst="rect">
            <a:avLst/>
          </a:prstGeom>
        </p:spPr>
        <p:txBody>
          <a:bodyPr wrap="square" lIns="45584" tIns="22792" rIns="45584" bIns="22792">
            <a:spAutoFit/>
          </a:bodyPr>
          <a:lstStyle/>
          <a:p>
            <a:pPr algn="just">
              <a:spcAft>
                <a:spcPts val="181"/>
              </a:spcAft>
            </a:pP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. S1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emical structures of high-ranking virtual screening hits from both docking- and similarity-based method. </a:t>
            </a:r>
            <a:endParaRPr lang="en-US" altLang="ko-KR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그림 5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9373" y="3044052"/>
            <a:ext cx="5634277" cy="1849002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10906264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직사각형 29">
            <a:extLst>
              <a:ext uri="{FF2B5EF4-FFF2-40B4-BE49-F238E27FC236}">
                <a16:creationId xmlns:a16="http://schemas.microsoft.com/office/drawing/2014/main" id="{B56CF648-CD79-4389-AE08-C388447F0273}"/>
              </a:ext>
            </a:extLst>
          </p:cNvPr>
          <p:cNvSpPr/>
          <p:nvPr/>
        </p:nvSpPr>
        <p:spPr>
          <a:xfrm>
            <a:off x="819066" y="6214196"/>
            <a:ext cx="5923126" cy="646193"/>
          </a:xfrm>
          <a:prstGeom prst="rect">
            <a:avLst/>
          </a:prstGeom>
        </p:spPr>
        <p:txBody>
          <a:bodyPr wrap="square" lIns="45584" tIns="22792" rIns="45584" bIns="22792">
            <a:spAutoFit/>
          </a:bodyPr>
          <a:lstStyle/>
          <a:p>
            <a:pPr algn="just">
              <a:spcAft>
                <a:spcPts val="181"/>
              </a:spcAft>
            </a:pP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. S2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ME inhibits H2B phosphorylation by S6K1 </a:t>
            </a:r>
            <a:r>
              <a:rPr lang="en-US" altLang="ko-KR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vitro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in</a:t>
            </a:r>
            <a:r>
              <a:rPr lang="en-US" altLang="ko-KR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itro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nase assay with RAME was performed in a dose dependent manner using recombinant H2B, active S6K1, and cold-ATP. </a:t>
            </a:r>
            <a:endParaRPr lang="en-US" altLang="ko-KR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7" name="Picture 10"/>
          <p:cNvPicPr>
            <a:picLocks noChangeArrowheads="1"/>
          </p:cNvPicPr>
          <p:nvPr/>
        </p:nvPicPr>
        <p:blipFill>
          <a:blip r:embed="rId2">
            <a:grayscl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62337" y="3994295"/>
            <a:ext cx="3348000" cy="3600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78" name="Picture 12"/>
          <p:cNvPicPr>
            <a:picLocks noChangeArrowheads="1"/>
          </p:cNvPicPr>
          <p:nvPr/>
        </p:nvPicPr>
        <p:blipFill>
          <a:blip r:embed="rId4">
            <a:grayscl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62337" y="4416576"/>
            <a:ext cx="3348000" cy="3600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79" name="Picture 14"/>
          <p:cNvPicPr>
            <a:picLocks noChangeArrowheads="1"/>
          </p:cNvPicPr>
          <p:nvPr/>
        </p:nvPicPr>
        <p:blipFill>
          <a:blip r:embed="rId6">
            <a:grayscl/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62337" y="4837288"/>
            <a:ext cx="3348000" cy="3600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80" name="TextBox 79">
            <a:extLst>
              <a:ext uri="{FF2B5EF4-FFF2-40B4-BE49-F238E27FC236}">
                <a16:creationId xmlns:a16="http://schemas.microsoft.com/office/drawing/2014/main" id="{15D84572-4F75-40FC-A20E-417ADA37531C}"/>
              </a:ext>
            </a:extLst>
          </p:cNvPr>
          <p:cNvSpPr txBox="1"/>
          <p:nvPr/>
        </p:nvSpPr>
        <p:spPr>
          <a:xfrm>
            <a:off x="2670005" y="3713199"/>
            <a:ext cx="239434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itchFamily="34" charset="0"/>
              </a:rPr>
              <a:t>- 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1503219F-9FD1-4E29-BF90-032B97323A7B}"/>
              </a:ext>
            </a:extLst>
          </p:cNvPr>
          <p:cNvSpPr txBox="1"/>
          <p:nvPr/>
        </p:nvSpPr>
        <p:spPr>
          <a:xfrm>
            <a:off x="1533102" y="3713199"/>
            <a:ext cx="97836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RAME (</a:t>
            </a:r>
            <a:r>
              <a:rPr lang="el-GR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4FB4B84F-7A88-46AE-9FEE-6811F14CA529}"/>
              </a:ext>
            </a:extLst>
          </p:cNvPr>
          <p:cNvSpPr txBox="1"/>
          <p:nvPr/>
        </p:nvSpPr>
        <p:spPr>
          <a:xfrm>
            <a:off x="1533102" y="3472289"/>
            <a:ext cx="97836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Active-S6K1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3FBDCAF7-2B5C-4A90-A512-9886F105C885}"/>
              </a:ext>
            </a:extLst>
          </p:cNvPr>
          <p:cNvSpPr txBox="1"/>
          <p:nvPr/>
        </p:nvSpPr>
        <p:spPr>
          <a:xfrm>
            <a:off x="1624207" y="3231380"/>
            <a:ext cx="8872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H2B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0C9ADCD8-9842-455D-A542-384162F97CF4}"/>
              </a:ext>
            </a:extLst>
          </p:cNvPr>
          <p:cNvSpPr txBox="1"/>
          <p:nvPr/>
        </p:nvSpPr>
        <p:spPr>
          <a:xfrm>
            <a:off x="1523781" y="2990471"/>
            <a:ext cx="9876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Cold-ATP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004613AC-0596-4C77-B946-9966C5740FBB}"/>
              </a:ext>
            </a:extLst>
          </p:cNvPr>
          <p:cNvSpPr txBox="1"/>
          <p:nvPr/>
        </p:nvSpPr>
        <p:spPr>
          <a:xfrm>
            <a:off x="3227857" y="3713199"/>
            <a:ext cx="239434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itchFamily="34" charset="0"/>
              </a:rPr>
              <a:t>- 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546E4306-393E-4021-A53F-B093F416F196}"/>
              </a:ext>
            </a:extLst>
          </p:cNvPr>
          <p:cNvSpPr txBox="1"/>
          <p:nvPr/>
        </p:nvSpPr>
        <p:spPr>
          <a:xfrm>
            <a:off x="3739762" y="3713199"/>
            <a:ext cx="372783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itchFamily="34" charset="0"/>
              </a:rPr>
              <a:t>10 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43B09948-AEA8-4AEE-A219-2A12C63A7352}"/>
              </a:ext>
            </a:extLst>
          </p:cNvPr>
          <p:cNvSpPr txBox="1"/>
          <p:nvPr/>
        </p:nvSpPr>
        <p:spPr>
          <a:xfrm>
            <a:off x="4202863" y="3713199"/>
            <a:ext cx="545794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itchFamily="34" charset="0"/>
              </a:rPr>
              <a:t>20 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DC53512C-195B-4A0D-991B-6DEDF36EC579}"/>
              </a:ext>
            </a:extLst>
          </p:cNvPr>
          <p:cNvSpPr txBox="1"/>
          <p:nvPr/>
        </p:nvSpPr>
        <p:spPr>
          <a:xfrm>
            <a:off x="4812805" y="3713199"/>
            <a:ext cx="372782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itchFamily="34" charset="0"/>
              </a:rPr>
              <a:t>40 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6D2C8A8C-EC55-4391-BD53-79B385761F78}"/>
              </a:ext>
            </a:extLst>
          </p:cNvPr>
          <p:cNvSpPr txBox="1"/>
          <p:nvPr/>
        </p:nvSpPr>
        <p:spPr>
          <a:xfrm>
            <a:off x="5330509" y="3713199"/>
            <a:ext cx="372782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itchFamily="34" charset="0"/>
              </a:rPr>
              <a:t>80 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E266F26D-DC49-4550-93CF-0469943FFCAE}"/>
              </a:ext>
            </a:extLst>
          </p:cNvPr>
          <p:cNvSpPr txBox="1"/>
          <p:nvPr/>
        </p:nvSpPr>
        <p:spPr>
          <a:xfrm>
            <a:off x="2670005" y="3469725"/>
            <a:ext cx="239434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itchFamily="34" charset="0"/>
              </a:rPr>
              <a:t>- 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59EE8C45-7B9A-4198-A504-50056A6DF80D}"/>
              </a:ext>
            </a:extLst>
          </p:cNvPr>
          <p:cNvSpPr txBox="1"/>
          <p:nvPr/>
        </p:nvSpPr>
        <p:spPr>
          <a:xfrm>
            <a:off x="3227857" y="3469725"/>
            <a:ext cx="239434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itchFamily="34" charset="0"/>
              </a:rPr>
              <a:t>+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674BB100-5770-4B30-ACD3-721E76CD3099}"/>
              </a:ext>
            </a:extLst>
          </p:cNvPr>
          <p:cNvSpPr txBox="1"/>
          <p:nvPr/>
        </p:nvSpPr>
        <p:spPr>
          <a:xfrm>
            <a:off x="3813005" y="3469725"/>
            <a:ext cx="239434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itchFamily="34" charset="0"/>
              </a:rPr>
              <a:t>+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1EBC6E88-8A2B-47FB-B9DF-BA32F0D8108B}"/>
              </a:ext>
            </a:extLst>
          </p:cNvPr>
          <p:cNvSpPr txBox="1"/>
          <p:nvPr/>
        </p:nvSpPr>
        <p:spPr>
          <a:xfrm>
            <a:off x="4343561" y="3469725"/>
            <a:ext cx="239434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itchFamily="34" charset="0"/>
              </a:rPr>
              <a:t>+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14BDA8F4-585E-4226-A8BC-1DEC0BB15992}"/>
              </a:ext>
            </a:extLst>
          </p:cNvPr>
          <p:cNvSpPr txBox="1"/>
          <p:nvPr/>
        </p:nvSpPr>
        <p:spPr>
          <a:xfrm>
            <a:off x="4892397" y="3469725"/>
            <a:ext cx="239434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itchFamily="34" charset="0"/>
              </a:rPr>
              <a:t>+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0231DA69-4C09-4C0E-A109-FABB78719BE8}"/>
              </a:ext>
            </a:extLst>
          </p:cNvPr>
          <p:cNvSpPr txBox="1"/>
          <p:nvPr/>
        </p:nvSpPr>
        <p:spPr>
          <a:xfrm>
            <a:off x="5368935" y="3469725"/>
            <a:ext cx="239434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itchFamily="34" charset="0"/>
              </a:rPr>
              <a:t>+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F6AA4A44-E6A7-4774-B92E-B3248F576B5B}"/>
              </a:ext>
            </a:extLst>
          </p:cNvPr>
          <p:cNvSpPr txBox="1"/>
          <p:nvPr/>
        </p:nvSpPr>
        <p:spPr>
          <a:xfrm>
            <a:off x="2670005" y="3226251"/>
            <a:ext cx="239434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itchFamily="34" charset="0"/>
              </a:rPr>
              <a:t>+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40956D56-0A37-4AB6-A33F-50D6D8258216}"/>
              </a:ext>
            </a:extLst>
          </p:cNvPr>
          <p:cNvSpPr txBox="1"/>
          <p:nvPr/>
        </p:nvSpPr>
        <p:spPr>
          <a:xfrm>
            <a:off x="3227857" y="3226251"/>
            <a:ext cx="239434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itchFamily="34" charset="0"/>
              </a:rPr>
              <a:t>+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AFCF40ED-539E-4526-9BCD-4C089ECB99CB}"/>
              </a:ext>
            </a:extLst>
          </p:cNvPr>
          <p:cNvSpPr txBox="1"/>
          <p:nvPr/>
        </p:nvSpPr>
        <p:spPr>
          <a:xfrm>
            <a:off x="3813005" y="3226251"/>
            <a:ext cx="239434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itchFamily="34" charset="0"/>
              </a:rPr>
              <a:t>+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15B66A45-01D4-4522-8B91-35E7C8DEDDB9}"/>
              </a:ext>
            </a:extLst>
          </p:cNvPr>
          <p:cNvSpPr txBox="1"/>
          <p:nvPr/>
        </p:nvSpPr>
        <p:spPr>
          <a:xfrm>
            <a:off x="4343561" y="3226251"/>
            <a:ext cx="239434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itchFamily="34" charset="0"/>
              </a:rPr>
              <a:t>+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21824DCB-C209-47FC-A8B4-37433B53C753}"/>
              </a:ext>
            </a:extLst>
          </p:cNvPr>
          <p:cNvSpPr txBox="1"/>
          <p:nvPr/>
        </p:nvSpPr>
        <p:spPr>
          <a:xfrm>
            <a:off x="4892397" y="3226251"/>
            <a:ext cx="239434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itchFamily="34" charset="0"/>
              </a:rPr>
              <a:t>+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020B8A5F-0390-494D-8E18-23331B57D4C1}"/>
              </a:ext>
            </a:extLst>
          </p:cNvPr>
          <p:cNvSpPr txBox="1"/>
          <p:nvPr/>
        </p:nvSpPr>
        <p:spPr>
          <a:xfrm>
            <a:off x="5368935" y="3226251"/>
            <a:ext cx="239434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itchFamily="34" charset="0"/>
              </a:rPr>
              <a:t>+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80B88087-62C3-478B-A217-E26484091552}"/>
              </a:ext>
            </a:extLst>
          </p:cNvPr>
          <p:cNvSpPr txBox="1"/>
          <p:nvPr/>
        </p:nvSpPr>
        <p:spPr>
          <a:xfrm>
            <a:off x="2670005" y="2982777"/>
            <a:ext cx="239434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itchFamily="34" charset="0"/>
              </a:rPr>
              <a:t>+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203E5C2E-B0D5-48F1-A291-FE26639D746E}"/>
              </a:ext>
            </a:extLst>
          </p:cNvPr>
          <p:cNvSpPr txBox="1"/>
          <p:nvPr/>
        </p:nvSpPr>
        <p:spPr>
          <a:xfrm>
            <a:off x="3227857" y="2982777"/>
            <a:ext cx="239434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itchFamily="34" charset="0"/>
              </a:rPr>
              <a:t>+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BFFFA1B8-8998-49CD-90FD-70F137B39342}"/>
              </a:ext>
            </a:extLst>
          </p:cNvPr>
          <p:cNvSpPr txBox="1"/>
          <p:nvPr/>
        </p:nvSpPr>
        <p:spPr>
          <a:xfrm>
            <a:off x="3813005" y="2982777"/>
            <a:ext cx="239434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itchFamily="34" charset="0"/>
              </a:rPr>
              <a:t>+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5798D43D-16CA-4F94-8352-BAA9419354D9}"/>
              </a:ext>
            </a:extLst>
          </p:cNvPr>
          <p:cNvSpPr txBox="1"/>
          <p:nvPr/>
        </p:nvSpPr>
        <p:spPr>
          <a:xfrm>
            <a:off x="4343561" y="2982777"/>
            <a:ext cx="239434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itchFamily="34" charset="0"/>
              </a:rPr>
              <a:t>+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7282ED50-C01E-4FC5-8E17-89A92B64F4D8}"/>
              </a:ext>
            </a:extLst>
          </p:cNvPr>
          <p:cNvSpPr txBox="1"/>
          <p:nvPr/>
        </p:nvSpPr>
        <p:spPr>
          <a:xfrm>
            <a:off x="4892397" y="2982777"/>
            <a:ext cx="239434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itchFamily="34" charset="0"/>
              </a:rPr>
              <a:t>+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7222E423-263C-4369-94A5-2A87837D78D3}"/>
              </a:ext>
            </a:extLst>
          </p:cNvPr>
          <p:cNvSpPr txBox="1"/>
          <p:nvPr/>
        </p:nvSpPr>
        <p:spPr>
          <a:xfrm>
            <a:off x="5368935" y="2982777"/>
            <a:ext cx="239434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itchFamily="34" charset="0"/>
              </a:rPr>
              <a:t>+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928D9BF0-A97B-4648-A22C-EFDB5C8343C0}"/>
              </a:ext>
            </a:extLst>
          </p:cNvPr>
          <p:cNvSpPr txBox="1"/>
          <p:nvPr/>
        </p:nvSpPr>
        <p:spPr>
          <a:xfrm>
            <a:off x="1435798" y="4024308"/>
            <a:ext cx="9783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S6K1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28C99024-C097-4AE1-9068-C29EDCDDBE17}"/>
              </a:ext>
            </a:extLst>
          </p:cNvPr>
          <p:cNvSpPr txBox="1"/>
          <p:nvPr/>
        </p:nvSpPr>
        <p:spPr>
          <a:xfrm>
            <a:off x="1433696" y="4451255"/>
            <a:ext cx="9783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H2BS36p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16E59E81-F2F2-4A3F-AA10-02D9BBBEA943}"/>
              </a:ext>
            </a:extLst>
          </p:cNvPr>
          <p:cNvSpPr txBox="1"/>
          <p:nvPr/>
        </p:nvSpPr>
        <p:spPr>
          <a:xfrm>
            <a:off x="1433696" y="4872868"/>
            <a:ext cx="9783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H2B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4175862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직사각형 51">
            <a:extLst>
              <a:ext uri="{FF2B5EF4-FFF2-40B4-BE49-F238E27FC236}">
                <a16:creationId xmlns:a16="http://schemas.microsoft.com/office/drawing/2014/main" id="{BE9F04FD-DAE3-419B-8A65-F6DC7E8DCF35}"/>
              </a:ext>
            </a:extLst>
          </p:cNvPr>
          <p:cNvSpPr/>
          <p:nvPr/>
        </p:nvSpPr>
        <p:spPr>
          <a:xfrm>
            <a:off x="819066" y="6635657"/>
            <a:ext cx="5923126" cy="446139"/>
          </a:xfrm>
          <a:prstGeom prst="rect">
            <a:avLst/>
          </a:prstGeom>
        </p:spPr>
        <p:txBody>
          <a:bodyPr wrap="square" lIns="45584" tIns="22792" rIns="45584" bIns="22792">
            <a:spAutoFit/>
          </a:bodyPr>
          <a:lstStyle/>
          <a:p>
            <a:pPr algn="just">
              <a:spcAft>
                <a:spcPts val="181"/>
              </a:spcAft>
            </a:pP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. S3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fects of RAME on lung cancer cell lines. Immunoblotting analysis of A549 and H1299 cells treated with RAME (40, 80 </a:t>
            </a:r>
            <a:r>
              <a:rPr lang="en-US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for 24 h.</a:t>
            </a:r>
            <a:endParaRPr lang="en-US" altLang="ko-KR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73AA46A8-DA7E-414D-953F-E2B05A7DCDA0}"/>
              </a:ext>
            </a:extLst>
          </p:cNvPr>
          <p:cNvSpPr txBox="1"/>
          <p:nvPr/>
        </p:nvSpPr>
        <p:spPr>
          <a:xfrm>
            <a:off x="1343798" y="3549290"/>
            <a:ext cx="7931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p-S6K1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7574E5CF-28D5-4374-916D-1ED37EBFCE38}"/>
              </a:ext>
            </a:extLst>
          </p:cNvPr>
          <p:cNvSpPr txBox="1"/>
          <p:nvPr/>
        </p:nvSpPr>
        <p:spPr>
          <a:xfrm>
            <a:off x="1343798" y="3958006"/>
            <a:ext cx="7931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S6K1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BD862B57-18C8-47E6-811D-106E00E38502}"/>
              </a:ext>
            </a:extLst>
          </p:cNvPr>
          <p:cNvSpPr txBox="1"/>
          <p:nvPr/>
        </p:nvSpPr>
        <p:spPr>
          <a:xfrm>
            <a:off x="1343798" y="4371111"/>
            <a:ext cx="7931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p-S6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AA082F46-E82F-4E4D-A211-F52C5FF49C8F}"/>
              </a:ext>
            </a:extLst>
          </p:cNvPr>
          <p:cNvSpPr txBox="1"/>
          <p:nvPr/>
        </p:nvSpPr>
        <p:spPr>
          <a:xfrm>
            <a:off x="1343798" y="4791702"/>
            <a:ext cx="7931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S6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16B876FA-7520-4005-BCC5-84ED68BE46A6}"/>
              </a:ext>
            </a:extLst>
          </p:cNvPr>
          <p:cNvSpPr txBox="1"/>
          <p:nvPr/>
        </p:nvSpPr>
        <p:spPr>
          <a:xfrm>
            <a:off x="1343798" y="5250082"/>
            <a:ext cx="7931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002AE7A-EBCB-4D3D-874E-E0C05601F08E}"/>
              </a:ext>
            </a:extLst>
          </p:cNvPr>
          <p:cNvSpPr txBox="1"/>
          <p:nvPr/>
        </p:nvSpPr>
        <p:spPr>
          <a:xfrm>
            <a:off x="2046830" y="3177323"/>
            <a:ext cx="6523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E30F22AB-4D26-4289-BE28-3735964B0599}"/>
              </a:ext>
            </a:extLst>
          </p:cNvPr>
          <p:cNvSpPr txBox="1"/>
          <p:nvPr/>
        </p:nvSpPr>
        <p:spPr>
          <a:xfrm>
            <a:off x="2632926" y="3177323"/>
            <a:ext cx="6523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l-GR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96180A40-9A52-49AB-923B-BB29A5B5148F}"/>
              </a:ext>
            </a:extLst>
          </p:cNvPr>
          <p:cNvSpPr txBox="1"/>
          <p:nvPr/>
        </p:nvSpPr>
        <p:spPr>
          <a:xfrm>
            <a:off x="3215320" y="3177323"/>
            <a:ext cx="6523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r>
              <a:rPr lang="el-GR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μ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556BCB3D-8E74-4C26-A0BF-F5F89792C546}"/>
              </a:ext>
            </a:extLst>
          </p:cNvPr>
          <p:cNvSpPr txBox="1"/>
          <p:nvPr/>
        </p:nvSpPr>
        <p:spPr>
          <a:xfrm>
            <a:off x="1484535" y="3235392"/>
            <a:ext cx="6523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RAME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A305537F-643E-463E-A80E-38AFC2040DC7}"/>
              </a:ext>
            </a:extLst>
          </p:cNvPr>
          <p:cNvSpPr txBox="1"/>
          <p:nvPr/>
        </p:nvSpPr>
        <p:spPr>
          <a:xfrm>
            <a:off x="3818130" y="3177323"/>
            <a:ext cx="6523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1E4B89B1-21D0-4B45-A1D3-6B82C294C3EE}"/>
              </a:ext>
            </a:extLst>
          </p:cNvPr>
          <p:cNvSpPr txBox="1"/>
          <p:nvPr/>
        </p:nvSpPr>
        <p:spPr>
          <a:xfrm>
            <a:off x="4395909" y="3177323"/>
            <a:ext cx="6523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l-GR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DF4D2987-6DFD-42FB-8D84-BC90D4FB9842}"/>
              </a:ext>
            </a:extLst>
          </p:cNvPr>
          <p:cNvSpPr txBox="1"/>
          <p:nvPr/>
        </p:nvSpPr>
        <p:spPr>
          <a:xfrm>
            <a:off x="4978303" y="3177323"/>
            <a:ext cx="6523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80 </a:t>
            </a:r>
            <a:r>
              <a:rPr lang="el-GR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FD1AF880-FF82-4E2B-9F92-592285F0F468}"/>
              </a:ext>
            </a:extLst>
          </p:cNvPr>
          <p:cNvSpPr txBox="1"/>
          <p:nvPr/>
        </p:nvSpPr>
        <p:spPr>
          <a:xfrm>
            <a:off x="2612655" y="2801806"/>
            <a:ext cx="6523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A549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C1DFFDC9-D262-409D-9D78-7C2A871952EF}"/>
              </a:ext>
            </a:extLst>
          </p:cNvPr>
          <p:cNvSpPr txBox="1"/>
          <p:nvPr/>
        </p:nvSpPr>
        <p:spPr>
          <a:xfrm>
            <a:off x="4397103" y="2801806"/>
            <a:ext cx="6523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H1299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7" name="그림 46">
            <a:extLst>
              <a:ext uri="{FF2B5EF4-FFF2-40B4-BE49-F238E27FC236}">
                <a16:creationId xmlns:a16="http://schemas.microsoft.com/office/drawing/2014/main" id="{941D42AB-1DD1-4EAF-904D-7EAB56D961D3}"/>
              </a:ext>
            </a:extLst>
          </p:cNvPr>
          <p:cNvPicPr>
            <a:picLocks/>
          </p:cNvPicPr>
          <p:nvPr/>
        </p:nvPicPr>
        <p:blipFill rotWithShape="1">
          <a:blip r:embed="rId2">
            <a:grayscl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30000"/>
                    </a14:imgEffect>
                  </a14:imgLayer>
                </a14:imgProps>
              </a:ext>
            </a:extLst>
          </a:blip>
          <a:srcRect r="22011"/>
          <a:stretch/>
        </p:blipFill>
        <p:spPr>
          <a:xfrm>
            <a:off x="2147895" y="3919860"/>
            <a:ext cx="1656000" cy="3600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48" name="그림 47">
            <a:extLst>
              <a:ext uri="{FF2B5EF4-FFF2-40B4-BE49-F238E27FC236}">
                <a16:creationId xmlns:a16="http://schemas.microsoft.com/office/drawing/2014/main" id="{602ECE28-6F8F-4E33-8113-1115A967AA8E}"/>
              </a:ext>
            </a:extLst>
          </p:cNvPr>
          <p:cNvPicPr>
            <a:picLocks/>
          </p:cNvPicPr>
          <p:nvPr/>
        </p:nvPicPr>
        <p:blipFill rotWithShape="1">
          <a:blip r:embed="rId4">
            <a:grayscl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30000"/>
                    </a14:imgEffect>
                  </a14:imgLayer>
                </a14:imgProps>
              </a:ext>
            </a:extLst>
          </a:blip>
          <a:srcRect r="23558"/>
          <a:stretch/>
        </p:blipFill>
        <p:spPr>
          <a:xfrm>
            <a:off x="3923385" y="3921740"/>
            <a:ext cx="1656000" cy="3600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49" name="그림 48">
            <a:extLst>
              <a:ext uri="{FF2B5EF4-FFF2-40B4-BE49-F238E27FC236}">
                <a16:creationId xmlns:a16="http://schemas.microsoft.com/office/drawing/2014/main" id="{4E047367-BEBB-46E5-810A-DF93F65118C5}"/>
              </a:ext>
            </a:extLst>
          </p:cNvPr>
          <p:cNvPicPr>
            <a:picLocks/>
          </p:cNvPicPr>
          <p:nvPr/>
        </p:nvPicPr>
        <p:blipFill rotWithShape="1">
          <a:blip r:embed="rId6">
            <a:grayscl/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15000" contrast="45000"/>
                    </a14:imgEffect>
                  </a14:imgLayer>
                </a14:imgProps>
              </a:ext>
            </a:extLst>
          </a:blip>
          <a:srcRect r="26243"/>
          <a:stretch/>
        </p:blipFill>
        <p:spPr>
          <a:xfrm>
            <a:off x="2147895" y="3490265"/>
            <a:ext cx="1656000" cy="3600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50" name="그림 49">
            <a:extLst>
              <a:ext uri="{FF2B5EF4-FFF2-40B4-BE49-F238E27FC236}">
                <a16:creationId xmlns:a16="http://schemas.microsoft.com/office/drawing/2014/main" id="{5BF63EEC-C9C5-4B7D-8FAC-B5EE31CA1195}"/>
              </a:ext>
            </a:extLst>
          </p:cNvPr>
          <p:cNvPicPr>
            <a:picLocks/>
          </p:cNvPicPr>
          <p:nvPr/>
        </p:nvPicPr>
        <p:blipFill rotWithShape="1">
          <a:blip r:embed="rId8">
            <a:grayscl/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7000" contrast="50000"/>
                    </a14:imgEffect>
                  </a14:imgLayer>
                </a14:imgProps>
              </a:ext>
            </a:extLst>
          </a:blip>
          <a:srcRect r="23558"/>
          <a:stretch/>
        </p:blipFill>
        <p:spPr>
          <a:xfrm>
            <a:off x="3923385" y="3492772"/>
            <a:ext cx="1656000" cy="3600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51" name="그림 50">
            <a:extLst>
              <a:ext uri="{FF2B5EF4-FFF2-40B4-BE49-F238E27FC236}">
                <a16:creationId xmlns:a16="http://schemas.microsoft.com/office/drawing/2014/main" id="{5A146889-BD5F-4F31-BA10-7626C5956E17}"/>
              </a:ext>
            </a:extLst>
          </p:cNvPr>
          <p:cNvPicPr>
            <a:picLocks/>
          </p:cNvPicPr>
          <p:nvPr/>
        </p:nvPicPr>
        <p:blipFill rotWithShape="1">
          <a:blip r:embed="rId10">
            <a:grayscl/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 contrast="30000"/>
                    </a14:imgEffect>
                  </a14:imgLayer>
                </a14:imgProps>
              </a:ext>
            </a:extLst>
          </a:blip>
          <a:srcRect l="-1" r="24242"/>
          <a:stretch/>
        </p:blipFill>
        <p:spPr>
          <a:xfrm>
            <a:off x="2147895" y="5208644"/>
            <a:ext cx="1656000" cy="3600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58" name="그림 57">
            <a:extLst>
              <a:ext uri="{FF2B5EF4-FFF2-40B4-BE49-F238E27FC236}">
                <a16:creationId xmlns:a16="http://schemas.microsoft.com/office/drawing/2014/main" id="{EC0D42EB-C1E0-4378-9844-6955B9F06923}"/>
              </a:ext>
            </a:extLst>
          </p:cNvPr>
          <p:cNvPicPr>
            <a:picLocks/>
          </p:cNvPicPr>
          <p:nvPr/>
        </p:nvPicPr>
        <p:blipFill rotWithShape="1">
          <a:blip r:embed="rId12">
            <a:grayscl/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 contrast="30000"/>
                    </a14:imgEffect>
                  </a14:imgLayer>
                </a14:imgProps>
              </a:ext>
            </a:extLst>
          </a:blip>
          <a:srcRect r="23558"/>
          <a:stretch/>
        </p:blipFill>
        <p:spPr>
          <a:xfrm>
            <a:off x="3923385" y="5208644"/>
            <a:ext cx="1656000" cy="3600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59" name="그림 58">
            <a:extLst>
              <a:ext uri="{FF2B5EF4-FFF2-40B4-BE49-F238E27FC236}">
                <a16:creationId xmlns:a16="http://schemas.microsoft.com/office/drawing/2014/main" id="{D3C765D3-A3F9-4077-BDBB-02C56942108F}"/>
              </a:ext>
            </a:extLst>
          </p:cNvPr>
          <p:cNvPicPr>
            <a:picLocks/>
          </p:cNvPicPr>
          <p:nvPr/>
        </p:nvPicPr>
        <p:blipFill rotWithShape="1">
          <a:blip r:embed="rId14">
            <a:grayscl/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20000" contrast="30000"/>
                    </a14:imgEffect>
                  </a14:imgLayer>
                </a14:imgProps>
              </a:ext>
            </a:extLst>
          </a:blip>
          <a:srcRect l="-1" r="24242"/>
          <a:stretch/>
        </p:blipFill>
        <p:spPr>
          <a:xfrm>
            <a:off x="2147895" y="4779050"/>
            <a:ext cx="1656000" cy="3600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85" name="그림 84">
            <a:extLst>
              <a:ext uri="{FF2B5EF4-FFF2-40B4-BE49-F238E27FC236}">
                <a16:creationId xmlns:a16="http://schemas.microsoft.com/office/drawing/2014/main" id="{9D78C918-8B8F-485B-BB44-EA0009705F7C}"/>
              </a:ext>
            </a:extLst>
          </p:cNvPr>
          <p:cNvPicPr>
            <a:picLocks/>
          </p:cNvPicPr>
          <p:nvPr/>
        </p:nvPicPr>
        <p:blipFill rotWithShape="1">
          <a:blip r:embed="rId16">
            <a:grayscl/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20000" contrast="30000"/>
                    </a14:imgEffect>
                  </a14:imgLayer>
                </a14:imgProps>
              </a:ext>
            </a:extLst>
          </a:blip>
          <a:srcRect r="23558"/>
          <a:stretch/>
        </p:blipFill>
        <p:spPr>
          <a:xfrm>
            <a:off x="3923385" y="4779676"/>
            <a:ext cx="1656000" cy="3600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86" name="그림 85">
            <a:extLst>
              <a:ext uri="{FF2B5EF4-FFF2-40B4-BE49-F238E27FC236}">
                <a16:creationId xmlns:a16="http://schemas.microsoft.com/office/drawing/2014/main" id="{F5FF5C37-F099-4AB8-A9AC-5BFC338A2D75}"/>
              </a:ext>
            </a:extLst>
          </p:cNvPr>
          <p:cNvPicPr>
            <a:picLocks/>
          </p:cNvPicPr>
          <p:nvPr/>
        </p:nvPicPr>
        <p:blipFill rotWithShape="1">
          <a:blip r:embed="rId18">
            <a:grayscl/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15000" contrast="40000"/>
                    </a14:imgEffect>
                  </a14:imgLayer>
                </a14:imgProps>
              </a:ext>
            </a:extLst>
          </a:blip>
          <a:srcRect t="1" r="26243" b="1"/>
          <a:stretch/>
        </p:blipFill>
        <p:spPr>
          <a:xfrm>
            <a:off x="2147895" y="4349455"/>
            <a:ext cx="1656000" cy="3600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87" name="그림 86">
            <a:extLst>
              <a:ext uri="{FF2B5EF4-FFF2-40B4-BE49-F238E27FC236}">
                <a16:creationId xmlns:a16="http://schemas.microsoft.com/office/drawing/2014/main" id="{1A7C066D-AD30-4C4E-A23E-2A575E392D90}"/>
              </a:ext>
            </a:extLst>
          </p:cNvPr>
          <p:cNvPicPr>
            <a:picLocks/>
          </p:cNvPicPr>
          <p:nvPr/>
        </p:nvPicPr>
        <p:blipFill rotWithShape="1">
          <a:blip r:embed="rId20">
            <a:grayscl/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20000" contrast="30000"/>
                    </a14:imgEffect>
                  </a14:imgLayer>
                </a14:imgProps>
              </a:ext>
            </a:extLst>
          </a:blip>
          <a:srcRect r="23558"/>
          <a:stretch/>
        </p:blipFill>
        <p:spPr>
          <a:xfrm>
            <a:off x="3923385" y="4350708"/>
            <a:ext cx="1656000" cy="3600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04364582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25CB22D5-178E-4C74-95B9-ABB53E44A92A}"/>
              </a:ext>
            </a:extLst>
          </p:cNvPr>
          <p:cNvSpPr txBox="1"/>
          <p:nvPr/>
        </p:nvSpPr>
        <p:spPr>
          <a:xfrm>
            <a:off x="2239592" y="3737589"/>
            <a:ext cx="670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P-</a:t>
            </a:r>
            <a:r>
              <a:rPr lang="en-US" altLang="ko-KR" sz="1400" dirty="0" err="1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36792C8-7A13-4BF9-8B54-4A4445A82068}"/>
              </a:ext>
            </a:extLst>
          </p:cNvPr>
          <p:cNvSpPr txBox="1"/>
          <p:nvPr/>
        </p:nvSpPr>
        <p:spPr>
          <a:xfrm>
            <a:off x="2211492" y="4170846"/>
            <a:ext cx="698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400" dirty="0" err="1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AF1C4D4-B1C7-4714-82B3-192E40EE064E}"/>
              </a:ext>
            </a:extLst>
          </p:cNvPr>
          <p:cNvSpPr txBox="1"/>
          <p:nvPr/>
        </p:nvSpPr>
        <p:spPr>
          <a:xfrm>
            <a:off x="2848676" y="3452259"/>
            <a:ext cx="6523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C2B07D2-CB0D-4D62-83D9-7491246CBDDE}"/>
              </a:ext>
            </a:extLst>
          </p:cNvPr>
          <p:cNvSpPr txBox="1"/>
          <p:nvPr/>
        </p:nvSpPr>
        <p:spPr>
          <a:xfrm>
            <a:off x="3437494" y="3452259"/>
            <a:ext cx="6523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RAME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E58CCE5-BC34-4DB9-ABB3-705DE631B3D0}"/>
              </a:ext>
            </a:extLst>
          </p:cNvPr>
          <p:cNvSpPr txBox="1"/>
          <p:nvPr/>
        </p:nvSpPr>
        <p:spPr>
          <a:xfrm>
            <a:off x="3988356" y="3452259"/>
            <a:ext cx="6523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PF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직사각형 11">
            <a:extLst>
              <a:ext uri="{FF2B5EF4-FFF2-40B4-BE49-F238E27FC236}">
                <a16:creationId xmlns:a16="http://schemas.microsoft.com/office/drawing/2014/main" id="{56CF0E58-8758-4A94-A966-E47BE70246F0}"/>
              </a:ext>
            </a:extLst>
          </p:cNvPr>
          <p:cNvSpPr/>
          <p:nvPr/>
        </p:nvSpPr>
        <p:spPr>
          <a:xfrm>
            <a:off x="819066" y="5458420"/>
            <a:ext cx="5923126" cy="646193"/>
          </a:xfrm>
          <a:prstGeom prst="rect">
            <a:avLst/>
          </a:prstGeom>
        </p:spPr>
        <p:txBody>
          <a:bodyPr wrap="square" lIns="45584" tIns="22792" rIns="45584" bIns="22792">
            <a:spAutoFit/>
          </a:bodyPr>
          <a:lstStyle/>
          <a:p>
            <a:pPr algn="just">
              <a:spcAft>
                <a:spcPts val="181"/>
              </a:spcAft>
            </a:pP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. S4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fects of RAME and PF-4708671 on phosphorylation of </a:t>
            </a:r>
            <a:r>
              <a:rPr lang="en-US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kt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Immunoblotting analysis of HeLa cells treated with RAME (40 </a:t>
            </a:r>
            <a:r>
              <a:rPr lang="en-US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r PF-4708671 (20 </a:t>
            </a:r>
            <a:r>
              <a:rPr lang="en-US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for 24 h. </a:t>
            </a:r>
          </a:p>
        </p:txBody>
      </p:sp>
      <p:pic>
        <p:nvPicPr>
          <p:cNvPr id="1027" name="Picture 3"/>
          <p:cNvPicPr>
            <a:picLocks noChangeArrowheads="1"/>
          </p:cNvPicPr>
          <p:nvPr/>
        </p:nvPicPr>
        <p:blipFill>
          <a:blip r:embed="rId2">
            <a:grayscl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10000" contras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32384" y="3729258"/>
            <a:ext cx="1656000" cy="36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1029" name="Picture 5"/>
          <p:cNvPicPr>
            <a:picLocks noChangeArrowheads="1"/>
          </p:cNvPicPr>
          <p:nvPr/>
        </p:nvPicPr>
        <p:blipFill>
          <a:blip r:embed="rId4" cstate="print">
            <a:grayscl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1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32384" y="4168313"/>
            <a:ext cx="1656000" cy="36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98C02386-6DB5-473A-91A4-EACE46DBE75A}"/>
              </a:ext>
            </a:extLst>
          </p:cNvPr>
          <p:cNvSpPr txBox="1"/>
          <p:nvPr/>
        </p:nvSpPr>
        <p:spPr>
          <a:xfrm>
            <a:off x="2079813" y="4604103"/>
            <a:ext cx="8301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Actin 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9DA61F3E-AC53-46C2-B60E-6E34DBBD419A}"/>
              </a:ext>
            </a:extLst>
          </p:cNvPr>
          <p:cNvPicPr>
            <a:picLocks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aturation sat="0"/>
                    </a14:imgEffect>
                    <a14:imgEffect>
                      <a14:brightnessContrast bright="20000" contrast="3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932384" y="4591402"/>
            <a:ext cx="1656000" cy="36000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57625047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직사각형 38">
            <a:extLst>
              <a:ext uri="{FF2B5EF4-FFF2-40B4-BE49-F238E27FC236}">
                <a16:creationId xmlns:a16="http://schemas.microsoft.com/office/drawing/2014/main" id="{56CF0E58-8758-4A94-A966-E47BE70246F0}"/>
              </a:ext>
            </a:extLst>
          </p:cNvPr>
          <p:cNvSpPr/>
          <p:nvPr/>
        </p:nvSpPr>
        <p:spPr>
          <a:xfrm>
            <a:off x="819066" y="7266454"/>
            <a:ext cx="5923126" cy="646193"/>
          </a:xfrm>
          <a:prstGeom prst="rect">
            <a:avLst/>
          </a:prstGeom>
        </p:spPr>
        <p:txBody>
          <a:bodyPr wrap="square" lIns="45584" tIns="22792" rIns="45584" bIns="22792">
            <a:spAutoFit/>
          </a:bodyPr>
          <a:lstStyle/>
          <a:p>
            <a:pPr algn="just">
              <a:spcAft>
                <a:spcPts val="181"/>
              </a:spcAft>
            </a:pP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. S5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ME induces apoptosis in cervical cancer cells. (A) Immunoblotting analysis of HeLa cells treated with RAME (40 or 80 </a:t>
            </a:r>
            <a:r>
              <a:rPr lang="en-US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for 24 h. (B) Flow cytometric analysis of HeLa cells treated with RAME (80 </a:t>
            </a:r>
            <a:r>
              <a:rPr lang="en-US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for 24 h. </a:t>
            </a:r>
          </a:p>
        </p:txBody>
      </p:sp>
      <p:pic>
        <p:nvPicPr>
          <p:cNvPr id="32" name="그림 31"/>
          <p:cNvPicPr preferRelativeResize="0">
            <a:picLocks/>
          </p:cNvPicPr>
          <p:nvPr/>
        </p:nvPicPr>
        <p:blipFill rotWithShape="1">
          <a:blip r:embed="rId2">
            <a:grayscl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13000" contrast="50000"/>
                    </a14:imgEffect>
                  </a14:imgLayer>
                </a14:imgProps>
              </a:ext>
            </a:extLst>
          </a:blip>
          <a:srcRect r="24505"/>
          <a:stretch/>
        </p:blipFill>
        <p:spPr>
          <a:xfrm>
            <a:off x="3032180" y="2557701"/>
            <a:ext cx="1656000" cy="360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33" name="그림 32"/>
          <p:cNvPicPr preferRelativeResize="0">
            <a:picLocks/>
          </p:cNvPicPr>
          <p:nvPr/>
        </p:nvPicPr>
        <p:blipFill rotWithShape="1">
          <a:blip r:embed="rId4">
            <a:grayscl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13000" contrast="50000"/>
                    </a14:imgEffect>
                  </a14:imgLayer>
                </a14:imgProps>
              </a:ext>
            </a:extLst>
          </a:blip>
          <a:srcRect r="24505"/>
          <a:stretch/>
        </p:blipFill>
        <p:spPr>
          <a:xfrm>
            <a:off x="3032180" y="2996756"/>
            <a:ext cx="1656000" cy="360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25CB22D5-178E-4C74-95B9-ABB53E44A92A}"/>
              </a:ext>
            </a:extLst>
          </p:cNvPr>
          <p:cNvSpPr txBox="1"/>
          <p:nvPr/>
        </p:nvSpPr>
        <p:spPr>
          <a:xfrm>
            <a:off x="2339388" y="2586814"/>
            <a:ext cx="670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136792C8-7A13-4BF9-8B54-4A4445A82068}"/>
              </a:ext>
            </a:extLst>
          </p:cNvPr>
          <p:cNvSpPr txBox="1"/>
          <p:nvPr/>
        </p:nvSpPr>
        <p:spPr>
          <a:xfrm>
            <a:off x="2311288" y="3006403"/>
            <a:ext cx="698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직사각형 35"/>
          <p:cNvSpPr/>
          <p:nvPr/>
        </p:nvSpPr>
        <p:spPr>
          <a:xfrm>
            <a:off x="1817832" y="1909242"/>
            <a:ext cx="605666" cy="37633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2000" b="1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A</a:t>
            </a:r>
            <a:endParaRPr lang="ko-KR" altLang="en-US" sz="20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3AF1C4D4-B1C7-4714-82B3-192E40EE064E}"/>
              </a:ext>
            </a:extLst>
          </p:cNvPr>
          <p:cNvSpPr txBox="1"/>
          <p:nvPr/>
        </p:nvSpPr>
        <p:spPr>
          <a:xfrm>
            <a:off x="2969254" y="2280702"/>
            <a:ext cx="6523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1C2B07D2-CB0D-4D62-83D9-7491246CBDDE}"/>
              </a:ext>
            </a:extLst>
          </p:cNvPr>
          <p:cNvSpPr txBox="1"/>
          <p:nvPr/>
        </p:nvSpPr>
        <p:spPr>
          <a:xfrm>
            <a:off x="3578854" y="2280702"/>
            <a:ext cx="6523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l-GR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1E58CCE5-BC34-4DB9-ABB3-705DE631B3D0}"/>
              </a:ext>
            </a:extLst>
          </p:cNvPr>
          <p:cNvSpPr txBox="1"/>
          <p:nvPr/>
        </p:nvSpPr>
        <p:spPr>
          <a:xfrm>
            <a:off x="4129716" y="2280702"/>
            <a:ext cx="6523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80 </a:t>
            </a:r>
            <a:r>
              <a:rPr lang="el-GR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직선 연결선 47">
            <a:extLst>
              <a:ext uri="{FF2B5EF4-FFF2-40B4-BE49-F238E27FC236}">
                <a16:creationId xmlns:a16="http://schemas.microsoft.com/office/drawing/2014/main" id="{9217627B-AFD3-488F-B4A8-B2C7AC229652}"/>
              </a:ext>
            </a:extLst>
          </p:cNvPr>
          <p:cNvCxnSpPr/>
          <p:nvPr/>
        </p:nvCxnSpPr>
        <p:spPr>
          <a:xfrm>
            <a:off x="3713723" y="2290227"/>
            <a:ext cx="9334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E7454DE1-A939-4C67-B8BD-1D07C51B6D9E}"/>
              </a:ext>
            </a:extLst>
          </p:cNvPr>
          <p:cNvSpPr txBox="1"/>
          <p:nvPr/>
        </p:nvSpPr>
        <p:spPr>
          <a:xfrm>
            <a:off x="3854251" y="2028031"/>
            <a:ext cx="6523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RAME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직사각형 49"/>
          <p:cNvSpPr/>
          <p:nvPr/>
        </p:nvSpPr>
        <p:spPr>
          <a:xfrm>
            <a:off x="1227282" y="4123234"/>
            <a:ext cx="605666" cy="37633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2000" b="1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B</a:t>
            </a:r>
            <a:endParaRPr lang="ko-KR" altLang="en-US" sz="20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52" name="그림 51">
            <a:extLst>
              <a:ext uri="{FF2B5EF4-FFF2-40B4-BE49-F238E27FC236}">
                <a16:creationId xmlns:a16="http://schemas.microsoft.com/office/drawing/2014/main" id="{3999E5EB-CC1E-44A2-8555-A4F0F493BE8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749526" y="4468625"/>
            <a:ext cx="1908000" cy="1778956"/>
          </a:xfrm>
          <a:prstGeom prst="rect">
            <a:avLst/>
          </a:prstGeom>
        </p:spPr>
      </p:pic>
      <p:pic>
        <p:nvPicPr>
          <p:cNvPr id="53" name="그림 52">
            <a:extLst>
              <a:ext uri="{FF2B5EF4-FFF2-40B4-BE49-F238E27FC236}">
                <a16:creationId xmlns:a16="http://schemas.microsoft.com/office/drawing/2014/main" id="{DB0F57DA-F617-433F-B8DC-7999DB5D356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982876" y="4468625"/>
            <a:ext cx="1908000" cy="1778956"/>
          </a:xfrm>
          <a:prstGeom prst="rect">
            <a:avLst/>
          </a:prstGeom>
        </p:spPr>
      </p:pic>
      <p:sp>
        <p:nvSpPr>
          <p:cNvPr id="54" name="TextBox 53">
            <a:extLst>
              <a:ext uri="{FF2B5EF4-FFF2-40B4-BE49-F238E27FC236}">
                <a16:creationId xmlns:a16="http://schemas.microsoft.com/office/drawing/2014/main" id="{17A7A3F3-29A0-4550-8959-A26E52C20241}"/>
              </a:ext>
            </a:extLst>
          </p:cNvPr>
          <p:cNvSpPr txBox="1"/>
          <p:nvPr/>
        </p:nvSpPr>
        <p:spPr>
          <a:xfrm>
            <a:off x="3111379" y="4511779"/>
            <a:ext cx="5903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3.1%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6C8CCBCA-E5C4-44A3-BA92-FE1B4E201412}"/>
              </a:ext>
            </a:extLst>
          </p:cNvPr>
          <p:cNvSpPr txBox="1"/>
          <p:nvPr/>
        </p:nvSpPr>
        <p:spPr>
          <a:xfrm>
            <a:off x="3111379" y="5665865"/>
            <a:ext cx="5903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.6%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19BFA8C3-FE5D-4A62-81C4-FBFA9D3A42BA}"/>
              </a:ext>
            </a:extLst>
          </p:cNvPr>
          <p:cNvSpPr txBox="1"/>
          <p:nvPr/>
        </p:nvSpPr>
        <p:spPr>
          <a:xfrm>
            <a:off x="5297062" y="4511779"/>
            <a:ext cx="64363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3.6%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F996728B-6163-4E8A-B120-92B63588BEEB}"/>
              </a:ext>
            </a:extLst>
          </p:cNvPr>
          <p:cNvSpPr txBox="1"/>
          <p:nvPr/>
        </p:nvSpPr>
        <p:spPr>
          <a:xfrm>
            <a:off x="5297062" y="5665865"/>
            <a:ext cx="64363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3.1%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17A7A3F3-29A0-4550-8959-A26E52C20241}"/>
              </a:ext>
            </a:extLst>
          </p:cNvPr>
          <p:cNvSpPr txBox="1"/>
          <p:nvPr/>
        </p:nvSpPr>
        <p:spPr>
          <a:xfrm>
            <a:off x="2019369" y="4511779"/>
            <a:ext cx="5903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3.2%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17A7A3F3-29A0-4550-8959-A26E52C20241}"/>
              </a:ext>
            </a:extLst>
          </p:cNvPr>
          <p:cNvSpPr txBox="1"/>
          <p:nvPr/>
        </p:nvSpPr>
        <p:spPr>
          <a:xfrm>
            <a:off x="4241989" y="4511779"/>
            <a:ext cx="5903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5.1%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E7454DE1-A939-4C67-B8BD-1D07C51B6D9E}"/>
              </a:ext>
            </a:extLst>
          </p:cNvPr>
          <p:cNvSpPr txBox="1"/>
          <p:nvPr/>
        </p:nvSpPr>
        <p:spPr>
          <a:xfrm>
            <a:off x="2501407" y="4192842"/>
            <a:ext cx="6523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E7454DE1-A939-4C67-B8BD-1D07C51B6D9E}"/>
              </a:ext>
            </a:extLst>
          </p:cNvPr>
          <p:cNvSpPr txBox="1"/>
          <p:nvPr/>
        </p:nvSpPr>
        <p:spPr>
          <a:xfrm>
            <a:off x="4726280" y="4192842"/>
            <a:ext cx="6523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RAME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429033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" name="직사각형 193">
            <a:extLst>
              <a:ext uri="{FF2B5EF4-FFF2-40B4-BE49-F238E27FC236}">
                <a16:creationId xmlns:a16="http://schemas.microsoft.com/office/drawing/2014/main" id="{ED1DFD63-1407-4FDB-8053-CE6D0675AF12}"/>
              </a:ext>
            </a:extLst>
          </p:cNvPr>
          <p:cNvSpPr/>
          <p:nvPr/>
        </p:nvSpPr>
        <p:spPr>
          <a:xfrm>
            <a:off x="819066" y="8128283"/>
            <a:ext cx="5923126" cy="1246358"/>
          </a:xfrm>
          <a:prstGeom prst="rect">
            <a:avLst/>
          </a:prstGeom>
        </p:spPr>
        <p:txBody>
          <a:bodyPr wrap="square" lIns="45584" tIns="22792" rIns="45584" bIns="22792">
            <a:spAutoFit/>
          </a:bodyPr>
          <a:lstStyle/>
          <a:p>
            <a:pPr algn="just">
              <a:spcAft>
                <a:spcPts val="181"/>
              </a:spcAft>
            </a:pP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. S6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 does not enhance the effects of cisplatin in cervical cancer cells.</a:t>
            </a: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altLang="ko-KR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 mRNA levels of autophagy-related genes in </a:t>
            </a:r>
            <a:r>
              <a:rPr lang="en-US" altLang="ko-KR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iHa</a:t>
            </a:r>
            <a:r>
              <a:rPr lang="en-US" altLang="ko-KR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cells treated with or without cisplatin (5 </a:t>
            </a:r>
            <a:r>
              <a:rPr lang="en-US" altLang="ko-KR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altLang="ko-KR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 and RA (80 </a:t>
            </a:r>
            <a:r>
              <a:rPr lang="en-US" altLang="ko-KR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altLang="ko-KR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for 24 h. (B) The mRNA levels of apoptosis, DNA repair, and cell cycle arrest marker genes in </a:t>
            </a:r>
            <a:r>
              <a:rPr lang="en-US" altLang="ko-KR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iHa</a:t>
            </a:r>
            <a:r>
              <a:rPr lang="en-US" altLang="ko-KR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cells treated with or without cisplatin (5 </a:t>
            </a:r>
            <a:r>
              <a:rPr lang="en-US" altLang="ko-KR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altLang="ko-KR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 and RA (80 </a:t>
            </a:r>
            <a:r>
              <a:rPr lang="en-US" altLang="ko-KR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altLang="ko-KR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for 24 h. Error bars correspond to mean ± SEM (n = 3). *p &lt; 0.05, **p &lt; 0.01, ***p &lt; 0.001; unpaired t test.</a:t>
            </a:r>
          </a:p>
        </p:txBody>
      </p:sp>
      <p:sp>
        <p:nvSpPr>
          <p:cNvPr id="202" name="직사각형 201">
            <a:extLst>
              <a:ext uri="{FF2B5EF4-FFF2-40B4-BE49-F238E27FC236}">
                <a16:creationId xmlns:a16="http://schemas.microsoft.com/office/drawing/2014/main" id="{D0FFE363-A8A4-43C5-977D-5031079FE155}"/>
              </a:ext>
            </a:extLst>
          </p:cNvPr>
          <p:cNvSpPr/>
          <p:nvPr/>
        </p:nvSpPr>
        <p:spPr>
          <a:xfrm>
            <a:off x="804847" y="1370053"/>
            <a:ext cx="605666" cy="37633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2000" b="1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A</a:t>
            </a:r>
            <a:endParaRPr lang="ko-KR" altLang="en-US" sz="20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203" name="차트 202">
            <a:extLst>
              <a:ext uri="{FF2B5EF4-FFF2-40B4-BE49-F238E27FC236}">
                <a16:creationId xmlns:a16="http://schemas.microsoft.com/office/drawing/2014/main" id="{64D42EEC-8491-40BD-8732-60F1F9853C1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18910678"/>
              </p:ext>
            </p:extLst>
          </p:nvPr>
        </p:nvGraphicFramePr>
        <p:xfrm>
          <a:off x="1327924" y="1519996"/>
          <a:ext cx="5004000" cy="266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04" name="TextBox 203">
            <a:extLst>
              <a:ext uri="{FF2B5EF4-FFF2-40B4-BE49-F238E27FC236}">
                <a16:creationId xmlns:a16="http://schemas.microsoft.com/office/drawing/2014/main" id="{3CA0FC56-EA2D-468D-8030-F7A597FEC103}"/>
              </a:ext>
            </a:extLst>
          </p:cNvPr>
          <p:cNvSpPr txBox="1"/>
          <p:nvPr/>
        </p:nvSpPr>
        <p:spPr>
          <a:xfrm rot="16200000">
            <a:off x="485035" y="2557877"/>
            <a:ext cx="1659035" cy="2043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800"/>
              </a:lnSpc>
            </a:pPr>
            <a:r>
              <a:rPr lang="en-US" altLang="ko-KR" sz="1200" dirty="0">
                <a:latin typeface="Arial" pitchFamily="34" charset="0"/>
                <a:cs typeface="Arial" pitchFamily="34" charset="0"/>
              </a:rPr>
              <a:t>Relative mRNA level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5" name="TextBox 204">
            <a:extLst>
              <a:ext uri="{FF2B5EF4-FFF2-40B4-BE49-F238E27FC236}">
                <a16:creationId xmlns:a16="http://schemas.microsoft.com/office/drawing/2014/main" id="{BBAC9F99-E3CB-4EE9-85B4-20DC11320247}"/>
              </a:ext>
            </a:extLst>
          </p:cNvPr>
          <p:cNvSpPr txBox="1"/>
          <p:nvPr/>
        </p:nvSpPr>
        <p:spPr>
          <a:xfrm>
            <a:off x="2589444" y="2465238"/>
            <a:ext cx="3717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*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6" name="왼쪽 대괄호 205">
            <a:extLst>
              <a:ext uri="{FF2B5EF4-FFF2-40B4-BE49-F238E27FC236}">
                <a16:creationId xmlns:a16="http://schemas.microsoft.com/office/drawing/2014/main" id="{1B8AD151-EA53-461D-B827-79A1F9BD8543}"/>
              </a:ext>
            </a:extLst>
          </p:cNvPr>
          <p:cNvSpPr/>
          <p:nvPr/>
        </p:nvSpPr>
        <p:spPr>
          <a:xfrm rot="5400000">
            <a:off x="2675353" y="2563825"/>
            <a:ext cx="57600" cy="1440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sz="1000" b="1"/>
          </a:p>
        </p:txBody>
      </p:sp>
      <p:sp>
        <p:nvSpPr>
          <p:cNvPr id="207" name="TextBox 206">
            <a:extLst>
              <a:ext uri="{FF2B5EF4-FFF2-40B4-BE49-F238E27FC236}">
                <a16:creationId xmlns:a16="http://schemas.microsoft.com/office/drawing/2014/main" id="{277E4A02-9FF9-4CF2-98D6-73E51F1895F5}"/>
              </a:ext>
            </a:extLst>
          </p:cNvPr>
          <p:cNvSpPr txBox="1"/>
          <p:nvPr/>
        </p:nvSpPr>
        <p:spPr>
          <a:xfrm>
            <a:off x="2630482" y="2279206"/>
            <a:ext cx="3717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**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8" name="왼쪽 대괄호 207">
            <a:extLst>
              <a:ext uri="{FF2B5EF4-FFF2-40B4-BE49-F238E27FC236}">
                <a16:creationId xmlns:a16="http://schemas.microsoft.com/office/drawing/2014/main" id="{73376954-5EBD-4A01-B549-D5B8D79959D8}"/>
              </a:ext>
            </a:extLst>
          </p:cNvPr>
          <p:cNvSpPr/>
          <p:nvPr/>
        </p:nvSpPr>
        <p:spPr>
          <a:xfrm rot="5400000">
            <a:off x="2732394" y="2297318"/>
            <a:ext cx="57600" cy="3240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sz="1000" b="1"/>
          </a:p>
        </p:txBody>
      </p:sp>
      <p:cxnSp>
        <p:nvCxnSpPr>
          <p:cNvPr id="209" name="직선 연결선 208">
            <a:extLst>
              <a:ext uri="{FF2B5EF4-FFF2-40B4-BE49-F238E27FC236}">
                <a16:creationId xmlns:a16="http://schemas.microsoft.com/office/drawing/2014/main" id="{5240BA6A-9BEF-4FC8-8E4A-36DDF74B3376}"/>
              </a:ext>
            </a:extLst>
          </p:cNvPr>
          <p:cNvCxnSpPr/>
          <p:nvPr/>
        </p:nvCxnSpPr>
        <p:spPr>
          <a:xfrm>
            <a:off x="2599194" y="2468023"/>
            <a:ext cx="0" cy="360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0" name="직선 연결선 209">
            <a:extLst>
              <a:ext uri="{FF2B5EF4-FFF2-40B4-BE49-F238E27FC236}">
                <a16:creationId xmlns:a16="http://schemas.microsoft.com/office/drawing/2014/main" id="{DF44399F-31DA-4746-B6DA-A7895D629DB0}"/>
              </a:ext>
            </a:extLst>
          </p:cNvPr>
          <p:cNvCxnSpPr/>
          <p:nvPr/>
        </p:nvCxnSpPr>
        <p:spPr>
          <a:xfrm>
            <a:off x="2632153" y="2655042"/>
            <a:ext cx="0" cy="180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1" name="TextBox 210">
            <a:extLst>
              <a:ext uri="{FF2B5EF4-FFF2-40B4-BE49-F238E27FC236}">
                <a16:creationId xmlns:a16="http://schemas.microsoft.com/office/drawing/2014/main" id="{9D80EB99-C1F4-4F82-A259-D301A0881759}"/>
              </a:ext>
            </a:extLst>
          </p:cNvPr>
          <p:cNvSpPr txBox="1"/>
          <p:nvPr/>
        </p:nvSpPr>
        <p:spPr>
          <a:xfrm>
            <a:off x="3255638" y="2524912"/>
            <a:ext cx="3717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*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2" name="왼쪽 대괄호 211">
            <a:extLst>
              <a:ext uri="{FF2B5EF4-FFF2-40B4-BE49-F238E27FC236}">
                <a16:creationId xmlns:a16="http://schemas.microsoft.com/office/drawing/2014/main" id="{B453AD15-FD3F-4B50-A351-62C9B192D7D0}"/>
              </a:ext>
            </a:extLst>
          </p:cNvPr>
          <p:cNvSpPr/>
          <p:nvPr/>
        </p:nvSpPr>
        <p:spPr>
          <a:xfrm rot="5400000">
            <a:off x="3341547" y="2623499"/>
            <a:ext cx="57600" cy="1440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sz="1000" b="1"/>
          </a:p>
        </p:txBody>
      </p:sp>
      <p:cxnSp>
        <p:nvCxnSpPr>
          <p:cNvPr id="213" name="직선 연결선 212">
            <a:extLst>
              <a:ext uri="{FF2B5EF4-FFF2-40B4-BE49-F238E27FC236}">
                <a16:creationId xmlns:a16="http://schemas.microsoft.com/office/drawing/2014/main" id="{EBDC6805-0D3D-4A05-BDDF-07835B324588}"/>
              </a:ext>
            </a:extLst>
          </p:cNvPr>
          <p:cNvCxnSpPr/>
          <p:nvPr/>
        </p:nvCxnSpPr>
        <p:spPr>
          <a:xfrm>
            <a:off x="3298347" y="2714716"/>
            <a:ext cx="0" cy="7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4" name="TextBox 213">
            <a:extLst>
              <a:ext uri="{FF2B5EF4-FFF2-40B4-BE49-F238E27FC236}">
                <a16:creationId xmlns:a16="http://schemas.microsoft.com/office/drawing/2014/main" id="{2E8AC4ED-CD30-497F-9DF7-34989D8E3D0A}"/>
              </a:ext>
            </a:extLst>
          </p:cNvPr>
          <p:cNvSpPr txBox="1"/>
          <p:nvPr/>
        </p:nvSpPr>
        <p:spPr>
          <a:xfrm>
            <a:off x="3938480" y="1838048"/>
            <a:ext cx="3717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*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5" name="왼쪽 대괄호 214">
            <a:extLst>
              <a:ext uri="{FF2B5EF4-FFF2-40B4-BE49-F238E27FC236}">
                <a16:creationId xmlns:a16="http://schemas.microsoft.com/office/drawing/2014/main" id="{9E10592E-BB75-483A-B943-FA279198204B}"/>
              </a:ext>
            </a:extLst>
          </p:cNvPr>
          <p:cNvSpPr/>
          <p:nvPr/>
        </p:nvSpPr>
        <p:spPr>
          <a:xfrm rot="5400000">
            <a:off x="4024389" y="1936635"/>
            <a:ext cx="57600" cy="1440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sz="1000" b="1"/>
          </a:p>
        </p:txBody>
      </p:sp>
      <p:sp>
        <p:nvSpPr>
          <p:cNvPr id="216" name="TextBox 215">
            <a:extLst>
              <a:ext uri="{FF2B5EF4-FFF2-40B4-BE49-F238E27FC236}">
                <a16:creationId xmlns:a16="http://schemas.microsoft.com/office/drawing/2014/main" id="{80F8BEB5-B793-45A0-8AF4-E28A1C632647}"/>
              </a:ext>
            </a:extLst>
          </p:cNvPr>
          <p:cNvSpPr txBox="1"/>
          <p:nvPr/>
        </p:nvSpPr>
        <p:spPr>
          <a:xfrm>
            <a:off x="3979518" y="1675766"/>
            <a:ext cx="3717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*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7" name="왼쪽 대괄호 216">
            <a:extLst>
              <a:ext uri="{FF2B5EF4-FFF2-40B4-BE49-F238E27FC236}">
                <a16:creationId xmlns:a16="http://schemas.microsoft.com/office/drawing/2014/main" id="{2102CAA1-607A-43F5-80CB-02EF233E821D}"/>
              </a:ext>
            </a:extLst>
          </p:cNvPr>
          <p:cNvSpPr/>
          <p:nvPr/>
        </p:nvSpPr>
        <p:spPr>
          <a:xfrm rot="5400000">
            <a:off x="4081430" y="1693878"/>
            <a:ext cx="57600" cy="3240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sz="1000" b="1"/>
          </a:p>
        </p:txBody>
      </p:sp>
      <p:cxnSp>
        <p:nvCxnSpPr>
          <p:cNvPr id="218" name="직선 연결선 217">
            <a:extLst>
              <a:ext uri="{FF2B5EF4-FFF2-40B4-BE49-F238E27FC236}">
                <a16:creationId xmlns:a16="http://schemas.microsoft.com/office/drawing/2014/main" id="{02CDB004-E06C-4549-AEFF-7DE65172C9A7}"/>
              </a:ext>
            </a:extLst>
          </p:cNvPr>
          <p:cNvCxnSpPr/>
          <p:nvPr/>
        </p:nvCxnSpPr>
        <p:spPr>
          <a:xfrm>
            <a:off x="3948230" y="1864583"/>
            <a:ext cx="0" cy="900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9" name="직선 연결선 218">
            <a:extLst>
              <a:ext uri="{FF2B5EF4-FFF2-40B4-BE49-F238E27FC236}">
                <a16:creationId xmlns:a16="http://schemas.microsoft.com/office/drawing/2014/main" id="{83811F1A-0B6A-4B19-836F-0838BFD1035A}"/>
              </a:ext>
            </a:extLst>
          </p:cNvPr>
          <p:cNvCxnSpPr/>
          <p:nvPr/>
        </p:nvCxnSpPr>
        <p:spPr>
          <a:xfrm>
            <a:off x="3981189" y="2027852"/>
            <a:ext cx="0" cy="720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0" name="TextBox 219">
            <a:extLst>
              <a:ext uri="{FF2B5EF4-FFF2-40B4-BE49-F238E27FC236}">
                <a16:creationId xmlns:a16="http://schemas.microsoft.com/office/drawing/2014/main" id="{20605FDD-65F9-4C62-BBB5-AD934A887BF9}"/>
              </a:ext>
            </a:extLst>
          </p:cNvPr>
          <p:cNvSpPr txBox="1"/>
          <p:nvPr/>
        </p:nvSpPr>
        <p:spPr>
          <a:xfrm>
            <a:off x="4622935" y="1990539"/>
            <a:ext cx="3717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*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1" name="왼쪽 대괄호 220">
            <a:extLst>
              <a:ext uri="{FF2B5EF4-FFF2-40B4-BE49-F238E27FC236}">
                <a16:creationId xmlns:a16="http://schemas.microsoft.com/office/drawing/2014/main" id="{0427C27C-7DD4-4238-84E6-AFA6ED1CF17F}"/>
              </a:ext>
            </a:extLst>
          </p:cNvPr>
          <p:cNvSpPr/>
          <p:nvPr/>
        </p:nvSpPr>
        <p:spPr>
          <a:xfrm rot="5400000">
            <a:off x="4708844" y="2089126"/>
            <a:ext cx="57600" cy="1440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sz="1000" b="1"/>
          </a:p>
        </p:txBody>
      </p:sp>
      <p:sp>
        <p:nvSpPr>
          <p:cNvPr id="222" name="TextBox 221">
            <a:extLst>
              <a:ext uri="{FF2B5EF4-FFF2-40B4-BE49-F238E27FC236}">
                <a16:creationId xmlns:a16="http://schemas.microsoft.com/office/drawing/2014/main" id="{7847EFBB-C5C3-449F-A3B2-EEF94D9D0BD5}"/>
              </a:ext>
            </a:extLst>
          </p:cNvPr>
          <p:cNvSpPr txBox="1"/>
          <p:nvPr/>
        </p:nvSpPr>
        <p:spPr>
          <a:xfrm>
            <a:off x="4652098" y="1733257"/>
            <a:ext cx="3717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*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3" name="왼쪽 대괄호 222">
            <a:extLst>
              <a:ext uri="{FF2B5EF4-FFF2-40B4-BE49-F238E27FC236}">
                <a16:creationId xmlns:a16="http://schemas.microsoft.com/office/drawing/2014/main" id="{E4F253EE-9ED7-4DB0-A43D-0ED38D8A8173}"/>
              </a:ext>
            </a:extLst>
          </p:cNvPr>
          <p:cNvSpPr/>
          <p:nvPr/>
        </p:nvSpPr>
        <p:spPr>
          <a:xfrm rot="5400000">
            <a:off x="4754010" y="1751369"/>
            <a:ext cx="57600" cy="3240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sz="1000" b="1"/>
          </a:p>
        </p:txBody>
      </p:sp>
      <p:cxnSp>
        <p:nvCxnSpPr>
          <p:cNvPr id="224" name="직선 연결선 223">
            <a:extLst>
              <a:ext uri="{FF2B5EF4-FFF2-40B4-BE49-F238E27FC236}">
                <a16:creationId xmlns:a16="http://schemas.microsoft.com/office/drawing/2014/main" id="{36A8F4A0-590D-43EC-86F0-8361B14869BC}"/>
              </a:ext>
            </a:extLst>
          </p:cNvPr>
          <p:cNvCxnSpPr/>
          <p:nvPr/>
        </p:nvCxnSpPr>
        <p:spPr>
          <a:xfrm>
            <a:off x="4620810" y="1922074"/>
            <a:ext cx="0" cy="864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5" name="직선 연결선 224">
            <a:extLst>
              <a:ext uri="{FF2B5EF4-FFF2-40B4-BE49-F238E27FC236}">
                <a16:creationId xmlns:a16="http://schemas.microsoft.com/office/drawing/2014/main" id="{DA21CEAE-C22F-4FE4-99F4-5797927985B6}"/>
              </a:ext>
            </a:extLst>
          </p:cNvPr>
          <p:cNvCxnSpPr/>
          <p:nvPr/>
        </p:nvCxnSpPr>
        <p:spPr>
          <a:xfrm>
            <a:off x="4665644" y="2180343"/>
            <a:ext cx="0" cy="576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6" name="TextBox 225">
            <a:extLst>
              <a:ext uri="{FF2B5EF4-FFF2-40B4-BE49-F238E27FC236}">
                <a16:creationId xmlns:a16="http://schemas.microsoft.com/office/drawing/2014/main" id="{4416A915-9FD0-4607-A25A-89F1A6EEC3FB}"/>
              </a:ext>
            </a:extLst>
          </p:cNvPr>
          <p:cNvSpPr txBox="1"/>
          <p:nvPr/>
        </p:nvSpPr>
        <p:spPr>
          <a:xfrm>
            <a:off x="5294757" y="2095312"/>
            <a:ext cx="3717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*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7" name="왼쪽 대괄호 226">
            <a:extLst>
              <a:ext uri="{FF2B5EF4-FFF2-40B4-BE49-F238E27FC236}">
                <a16:creationId xmlns:a16="http://schemas.microsoft.com/office/drawing/2014/main" id="{DF61BE6A-D4CD-4887-9D41-B199C9260C03}"/>
              </a:ext>
            </a:extLst>
          </p:cNvPr>
          <p:cNvSpPr/>
          <p:nvPr/>
        </p:nvSpPr>
        <p:spPr>
          <a:xfrm rot="5400000">
            <a:off x="5380666" y="2193899"/>
            <a:ext cx="57600" cy="1440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sz="1000" b="1"/>
          </a:p>
        </p:txBody>
      </p:sp>
      <p:sp>
        <p:nvSpPr>
          <p:cNvPr id="228" name="TextBox 227">
            <a:extLst>
              <a:ext uri="{FF2B5EF4-FFF2-40B4-BE49-F238E27FC236}">
                <a16:creationId xmlns:a16="http://schemas.microsoft.com/office/drawing/2014/main" id="{28FBAF45-1CB7-46A6-9ED0-BEAA0F41F21B}"/>
              </a:ext>
            </a:extLst>
          </p:cNvPr>
          <p:cNvSpPr txBox="1"/>
          <p:nvPr/>
        </p:nvSpPr>
        <p:spPr>
          <a:xfrm>
            <a:off x="5323920" y="1939411"/>
            <a:ext cx="3717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*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9" name="왼쪽 대괄호 228">
            <a:extLst>
              <a:ext uri="{FF2B5EF4-FFF2-40B4-BE49-F238E27FC236}">
                <a16:creationId xmlns:a16="http://schemas.microsoft.com/office/drawing/2014/main" id="{43614F3B-B207-4AC7-A039-9EA3493591A7}"/>
              </a:ext>
            </a:extLst>
          </p:cNvPr>
          <p:cNvSpPr/>
          <p:nvPr/>
        </p:nvSpPr>
        <p:spPr>
          <a:xfrm rot="5400000">
            <a:off x="5425832" y="1957523"/>
            <a:ext cx="57600" cy="3240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sz="1000" b="1"/>
          </a:p>
        </p:txBody>
      </p:sp>
      <p:cxnSp>
        <p:nvCxnSpPr>
          <p:cNvPr id="230" name="직선 연결선 229">
            <a:extLst>
              <a:ext uri="{FF2B5EF4-FFF2-40B4-BE49-F238E27FC236}">
                <a16:creationId xmlns:a16="http://schemas.microsoft.com/office/drawing/2014/main" id="{8A13254F-789F-4C17-986A-95F696A99A90}"/>
              </a:ext>
            </a:extLst>
          </p:cNvPr>
          <p:cNvCxnSpPr/>
          <p:nvPr/>
        </p:nvCxnSpPr>
        <p:spPr>
          <a:xfrm>
            <a:off x="5292632" y="2128228"/>
            <a:ext cx="0" cy="648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1" name="직선 연결선 230">
            <a:extLst>
              <a:ext uri="{FF2B5EF4-FFF2-40B4-BE49-F238E27FC236}">
                <a16:creationId xmlns:a16="http://schemas.microsoft.com/office/drawing/2014/main" id="{A2FD9074-8510-44DA-8CB2-00A7719FF00C}"/>
              </a:ext>
            </a:extLst>
          </p:cNvPr>
          <p:cNvCxnSpPr/>
          <p:nvPr/>
        </p:nvCxnSpPr>
        <p:spPr>
          <a:xfrm>
            <a:off x="5337466" y="2285116"/>
            <a:ext cx="0" cy="468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32" name="차트 231">
            <a:extLst>
              <a:ext uri="{FF2B5EF4-FFF2-40B4-BE49-F238E27FC236}">
                <a16:creationId xmlns:a16="http://schemas.microsoft.com/office/drawing/2014/main" id="{FBC49AD0-286C-4C10-9C20-CC876A81048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76925968"/>
              </p:ext>
            </p:extLst>
          </p:nvPr>
        </p:nvGraphicFramePr>
        <p:xfrm>
          <a:off x="1328662" y="4651620"/>
          <a:ext cx="5040000" cy="259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33" name="직사각형 232">
            <a:extLst>
              <a:ext uri="{FF2B5EF4-FFF2-40B4-BE49-F238E27FC236}">
                <a16:creationId xmlns:a16="http://schemas.microsoft.com/office/drawing/2014/main" id="{52E70A1F-7D90-4076-9097-EB3AC9400C41}"/>
              </a:ext>
            </a:extLst>
          </p:cNvPr>
          <p:cNvSpPr/>
          <p:nvPr/>
        </p:nvSpPr>
        <p:spPr>
          <a:xfrm>
            <a:off x="897983" y="4537535"/>
            <a:ext cx="605666" cy="394553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2000" b="1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234" name="TextBox 233">
            <a:extLst>
              <a:ext uri="{FF2B5EF4-FFF2-40B4-BE49-F238E27FC236}">
                <a16:creationId xmlns:a16="http://schemas.microsoft.com/office/drawing/2014/main" id="{2BB16937-5790-4B22-90C3-767668E0DD4C}"/>
              </a:ext>
            </a:extLst>
          </p:cNvPr>
          <p:cNvSpPr txBox="1"/>
          <p:nvPr/>
        </p:nvSpPr>
        <p:spPr>
          <a:xfrm rot="16200000">
            <a:off x="540025" y="5685072"/>
            <a:ext cx="1659035" cy="2043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800"/>
              </a:lnSpc>
            </a:pPr>
            <a:r>
              <a:rPr lang="en-US" altLang="ko-KR" sz="1200" dirty="0">
                <a:latin typeface="Arial" pitchFamily="34" charset="0"/>
                <a:cs typeface="Arial" pitchFamily="34" charset="0"/>
              </a:rPr>
              <a:t>Relative mRNA level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5" name="TextBox 234">
            <a:extLst>
              <a:ext uri="{FF2B5EF4-FFF2-40B4-BE49-F238E27FC236}">
                <a16:creationId xmlns:a16="http://schemas.microsoft.com/office/drawing/2014/main" id="{F911C852-6543-4A3C-ACD6-EC6282DE1163}"/>
              </a:ext>
            </a:extLst>
          </p:cNvPr>
          <p:cNvSpPr txBox="1"/>
          <p:nvPr/>
        </p:nvSpPr>
        <p:spPr>
          <a:xfrm>
            <a:off x="1883584" y="5999843"/>
            <a:ext cx="3717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**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6" name="왼쪽 대괄호 235">
            <a:extLst>
              <a:ext uri="{FF2B5EF4-FFF2-40B4-BE49-F238E27FC236}">
                <a16:creationId xmlns:a16="http://schemas.microsoft.com/office/drawing/2014/main" id="{DEEC83CB-74C7-4F44-B297-D9D2A7D6964D}"/>
              </a:ext>
            </a:extLst>
          </p:cNvPr>
          <p:cNvSpPr/>
          <p:nvPr/>
        </p:nvSpPr>
        <p:spPr>
          <a:xfrm rot="5400000">
            <a:off x="1992545" y="6098430"/>
            <a:ext cx="57600" cy="1440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sz="1000" b="1"/>
          </a:p>
        </p:txBody>
      </p:sp>
      <p:sp>
        <p:nvSpPr>
          <p:cNvPr id="237" name="TextBox 236">
            <a:extLst>
              <a:ext uri="{FF2B5EF4-FFF2-40B4-BE49-F238E27FC236}">
                <a16:creationId xmlns:a16="http://schemas.microsoft.com/office/drawing/2014/main" id="{A1943B62-3EC7-40E2-99B7-2DB8AAD0985C}"/>
              </a:ext>
            </a:extLst>
          </p:cNvPr>
          <p:cNvSpPr txBox="1"/>
          <p:nvPr/>
        </p:nvSpPr>
        <p:spPr>
          <a:xfrm>
            <a:off x="1897565" y="5836863"/>
            <a:ext cx="3717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***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8" name="왼쪽 대괄호 237">
            <a:extLst>
              <a:ext uri="{FF2B5EF4-FFF2-40B4-BE49-F238E27FC236}">
                <a16:creationId xmlns:a16="http://schemas.microsoft.com/office/drawing/2014/main" id="{9E3C05AE-B029-4A16-861B-5631348F280F}"/>
              </a:ext>
            </a:extLst>
          </p:cNvPr>
          <p:cNvSpPr/>
          <p:nvPr/>
        </p:nvSpPr>
        <p:spPr>
          <a:xfrm rot="5400000">
            <a:off x="2049586" y="5854975"/>
            <a:ext cx="57600" cy="3240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sz="1000" b="1"/>
          </a:p>
        </p:txBody>
      </p:sp>
      <p:cxnSp>
        <p:nvCxnSpPr>
          <p:cNvPr id="239" name="직선 연결선 238">
            <a:extLst>
              <a:ext uri="{FF2B5EF4-FFF2-40B4-BE49-F238E27FC236}">
                <a16:creationId xmlns:a16="http://schemas.microsoft.com/office/drawing/2014/main" id="{1D92C5C7-07F8-49CB-BBA8-0D665070726A}"/>
              </a:ext>
            </a:extLst>
          </p:cNvPr>
          <p:cNvCxnSpPr/>
          <p:nvPr/>
        </p:nvCxnSpPr>
        <p:spPr>
          <a:xfrm>
            <a:off x="1916386" y="6025680"/>
            <a:ext cx="0" cy="468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0" name="직선 연결선 239">
            <a:extLst>
              <a:ext uri="{FF2B5EF4-FFF2-40B4-BE49-F238E27FC236}">
                <a16:creationId xmlns:a16="http://schemas.microsoft.com/office/drawing/2014/main" id="{32B4E536-5F1C-4287-A104-F1829FD81D73}"/>
              </a:ext>
            </a:extLst>
          </p:cNvPr>
          <p:cNvCxnSpPr/>
          <p:nvPr/>
        </p:nvCxnSpPr>
        <p:spPr>
          <a:xfrm>
            <a:off x="1949345" y="6189647"/>
            <a:ext cx="0" cy="324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1" name="TextBox 240">
            <a:extLst>
              <a:ext uri="{FF2B5EF4-FFF2-40B4-BE49-F238E27FC236}">
                <a16:creationId xmlns:a16="http://schemas.microsoft.com/office/drawing/2014/main" id="{87DD71BA-32A8-4C53-BFD9-87869BEBFB3D}"/>
              </a:ext>
            </a:extLst>
          </p:cNvPr>
          <p:cNvSpPr txBox="1"/>
          <p:nvPr/>
        </p:nvSpPr>
        <p:spPr>
          <a:xfrm>
            <a:off x="2571382" y="5962534"/>
            <a:ext cx="3717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**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2" name="왼쪽 대괄호 241">
            <a:extLst>
              <a:ext uri="{FF2B5EF4-FFF2-40B4-BE49-F238E27FC236}">
                <a16:creationId xmlns:a16="http://schemas.microsoft.com/office/drawing/2014/main" id="{6D038B5E-B149-447B-B670-4D97E791603C}"/>
              </a:ext>
            </a:extLst>
          </p:cNvPr>
          <p:cNvSpPr/>
          <p:nvPr/>
        </p:nvSpPr>
        <p:spPr>
          <a:xfrm rot="5400000">
            <a:off x="2680343" y="6061121"/>
            <a:ext cx="57600" cy="1440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sz="1000" b="1"/>
          </a:p>
        </p:txBody>
      </p:sp>
      <p:sp>
        <p:nvSpPr>
          <p:cNvPr id="243" name="TextBox 242">
            <a:extLst>
              <a:ext uri="{FF2B5EF4-FFF2-40B4-BE49-F238E27FC236}">
                <a16:creationId xmlns:a16="http://schemas.microsoft.com/office/drawing/2014/main" id="{39AD9B64-D377-4CB4-B08E-866773F15FA5}"/>
              </a:ext>
            </a:extLst>
          </p:cNvPr>
          <p:cNvSpPr txBox="1"/>
          <p:nvPr/>
        </p:nvSpPr>
        <p:spPr>
          <a:xfrm>
            <a:off x="2585363" y="5799554"/>
            <a:ext cx="3717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***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4" name="왼쪽 대괄호 243">
            <a:extLst>
              <a:ext uri="{FF2B5EF4-FFF2-40B4-BE49-F238E27FC236}">
                <a16:creationId xmlns:a16="http://schemas.microsoft.com/office/drawing/2014/main" id="{E7181CDB-71BB-46FF-87EF-823AF25F1B1A}"/>
              </a:ext>
            </a:extLst>
          </p:cNvPr>
          <p:cNvSpPr/>
          <p:nvPr/>
        </p:nvSpPr>
        <p:spPr>
          <a:xfrm rot="5400000">
            <a:off x="2737384" y="5817666"/>
            <a:ext cx="57600" cy="3240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sz="1000" b="1"/>
          </a:p>
        </p:txBody>
      </p:sp>
      <p:cxnSp>
        <p:nvCxnSpPr>
          <p:cNvPr id="245" name="직선 연결선 244">
            <a:extLst>
              <a:ext uri="{FF2B5EF4-FFF2-40B4-BE49-F238E27FC236}">
                <a16:creationId xmlns:a16="http://schemas.microsoft.com/office/drawing/2014/main" id="{B77218EA-F6A7-42AE-BB92-CD674BF36250}"/>
              </a:ext>
            </a:extLst>
          </p:cNvPr>
          <p:cNvCxnSpPr/>
          <p:nvPr/>
        </p:nvCxnSpPr>
        <p:spPr>
          <a:xfrm>
            <a:off x="2604184" y="5988371"/>
            <a:ext cx="0" cy="540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6" name="직선 연결선 245">
            <a:extLst>
              <a:ext uri="{FF2B5EF4-FFF2-40B4-BE49-F238E27FC236}">
                <a16:creationId xmlns:a16="http://schemas.microsoft.com/office/drawing/2014/main" id="{3A1C8C0F-E3A2-46EF-84EA-9AB37551C988}"/>
              </a:ext>
            </a:extLst>
          </p:cNvPr>
          <p:cNvCxnSpPr/>
          <p:nvPr/>
        </p:nvCxnSpPr>
        <p:spPr>
          <a:xfrm>
            <a:off x="2637143" y="6152338"/>
            <a:ext cx="0" cy="360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7" name="TextBox 246">
            <a:extLst>
              <a:ext uri="{FF2B5EF4-FFF2-40B4-BE49-F238E27FC236}">
                <a16:creationId xmlns:a16="http://schemas.microsoft.com/office/drawing/2014/main" id="{D617405A-1BA9-4B08-B776-907CBBDCE656}"/>
              </a:ext>
            </a:extLst>
          </p:cNvPr>
          <p:cNvSpPr txBox="1"/>
          <p:nvPr/>
        </p:nvSpPr>
        <p:spPr>
          <a:xfrm>
            <a:off x="3242424" y="5696248"/>
            <a:ext cx="3717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*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8" name="왼쪽 대괄호 247">
            <a:extLst>
              <a:ext uri="{FF2B5EF4-FFF2-40B4-BE49-F238E27FC236}">
                <a16:creationId xmlns:a16="http://schemas.microsoft.com/office/drawing/2014/main" id="{1BD1899A-FA50-4078-9EF3-304E81EBD2CC}"/>
              </a:ext>
            </a:extLst>
          </p:cNvPr>
          <p:cNvSpPr/>
          <p:nvPr/>
        </p:nvSpPr>
        <p:spPr>
          <a:xfrm rot="5400000">
            <a:off x="3351385" y="5794835"/>
            <a:ext cx="57600" cy="1440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sz="1000" b="1"/>
          </a:p>
        </p:txBody>
      </p:sp>
      <p:cxnSp>
        <p:nvCxnSpPr>
          <p:cNvPr id="249" name="직선 연결선 248">
            <a:extLst>
              <a:ext uri="{FF2B5EF4-FFF2-40B4-BE49-F238E27FC236}">
                <a16:creationId xmlns:a16="http://schemas.microsoft.com/office/drawing/2014/main" id="{5C5EA213-657D-49BC-B3DD-AC1B9D5B2816}"/>
              </a:ext>
            </a:extLst>
          </p:cNvPr>
          <p:cNvCxnSpPr/>
          <p:nvPr/>
        </p:nvCxnSpPr>
        <p:spPr>
          <a:xfrm>
            <a:off x="3308185" y="5874207"/>
            <a:ext cx="0" cy="61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0" name="TextBox 249">
            <a:extLst>
              <a:ext uri="{FF2B5EF4-FFF2-40B4-BE49-F238E27FC236}">
                <a16:creationId xmlns:a16="http://schemas.microsoft.com/office/drawing/2014/main" id="{CD43667B-1937-47C7-B71E-2215F0EEC165}"/>
              </a:ext>
            </a:extLst>
          </p:cNvPr>
          <p:cNvSpPr txBox="1"/>
          <p:nvPr/>
        </p:nvSpPr>
        <p:spPr>
          <a:xfrm>
            <a:off x="3902660" y="5880983"/>
            <a:ext cx="3717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***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1" name="왼쪽 대괄호 250">
            <a:extLst>
              <a:ext uri="{FF2B5EF4-FFF2-40B4-BE49-F238E27FC236}">
                <a16:creationId xmlns:a16="http://schemas.microsoft.com/office/drawing/2014/main" id="{97A433D2-5DB1-4793-8DD3-22CDD2FFEA47}"/>
              </a:ext>
            </a:extLst>
          </p:cNvPr>
          <p:cNvSpPr/>
          <p:nvPr/>
        </p:nvSpPr>
        <p:spPr>
          <a:xfrm rot="5400000">
            <a:off x="4042357" y="5979570"/>
            <a:ext cx="57600" cy="1440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sz="1000" b="1"/>
          </a:p>
        </p:txBody>
      </p:sp>
      <p:sp>
        <p:nvSpPr>
          <p:cNvPr id="252" name="TextBox 251">
            <a:extLst>
              <a:ext uri="{FF2B5EF4-FFF2-40B4-BE49-F238E27FC236}">
                <a16:creationId xmlns:a16="http://schemas.microsoft.com/office/drawing/2014/main" id="{379DCC17-9A8A-4FD1-ADC1-DBAA41E117FB}"/>
              </a:ext>
            </a:extLst>
          </p:cNvPr>
          <p:cNvSpPr txBox="1"/>
          <p:nvPr/>
        </p:nvSpPr>
        <p:spPr>
          <a:xfrm>
            <a:off x="3947377" y="5049792"/>
            <a:ext cx="3717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***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3" name="왼쪽 대괄호 252">
            <a:extLst>
              <a:ext uri="{FF2B5EF4-FFF2-40B4-BE49-F238E27FC236}">
                <a16:creationId xmlns:a16="http://schemas.microsoft.com/office/drawing/2014/main" id="{2C1A0BC6-7B5C-4665-9BCB-3BBFBEE4B78B}"/>
              </a:ext>
            </a:extLst>
          </p:cNvPr>
          <p:cNvSpPr/>
          <p:nvPr/>
        </p:nvSpPr>
        <p:spPr>
          <a:xfrm rot="5400000">
            <a:off x="4099398" y="5067904"/>
            <a:ext cx="57600" cy="3240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sz="1000" b="1"/>
          </a:p>
        </p:txBody>
      </p:sp>
      <p:cxnSp>
        <p:nvCxnSpPr>
          <p:cNvPr id="254" name="직선 연결선 253">
            <a:extLst>
              <a:ext uri="{FF2B5EF4-FFF2-40B4-BE49-F238E27FC236}">
                <a16:creationId xmlns:a16="http://schemas.microsoft.com/office/drawing/2014/main" id="{4DD49FE8-4EA0-4B9B-BF2E-5A96EFDCFFC7}"/>
              </a:ext>
            </a:extLst>
          </p:cNvPr>
          <p:cNvCxnSpPr/>
          <p:nvPr/>
        </p:nvCxnSpPr>
        <p:spPr>
          <a:xfrm>
            <a:off x="3966198" y="5238609"/>
            <a:ext cx="0" cy="1260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5" name="직선 연결선 254">
            <a:extLst>
              <a:ext uri="{FF2B5EF4-FFF2-40B4-BE49-F238E27FC236}">
                <a16:creationId xmlns:a16="http://schemas.microsoft.com/office/drawing/2014/main" id="{0EA078EF-097D-452C-8EE5-C9F71F7A5C6B}"/>
              </a:ext>
            </a:extLst>
          </p:cNvPr>
          <p:cNvCxnSpPr/>
          <p:nvPr/>
        </p:nvCxnSpPr>
        <p:spPr>
          <a:xfrm>
            <a:off x="3999157" y="6070787"/>
            <a:ext cx="0" cy="43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6" name="TextBox 255">
            <a:extLst>
              <a:ext uri="{FF2B5EF4-FFF2-40B4-BE49-F238E27FC236}">
                <a16:creationId xmlns:a16="http://schemas.microsoft.com/office/drawing/2014/main" id="{B8B5922E-2ACD-4301-B492-D46C4F465FBD}"/>
              </a:ext>
            </a:extLst>
          </p:cNvPr>
          <p:cNvSpPr txBox="1"/>
          <p:nvPr/>
        </p:nvSpPr>
        <p:spPr>
          <a:xfrm>
            <a:off x="4094209" y="5257593"/>
            <a:ext cx="3717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**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7" name="왼쪽 대괄호 256">
            <a:extLst>
              <a:ext uri="{FF2B5EF4-FFF2-40B4-BE49-F238E27FC236}">
                <a16:creationId xmlns:a16="http://schemas.microsoft.com/office/drawing/2014/main" id="{8973B9B5-A860-4D0E-B2D8-DF3AD1CB3882}"/>
              </a:ext>
            </a:extLst>
          </p:cNvPr>
          <p:cNvSpPr/>
          <p:nvPr/>
        </p:nvSpPr>
        <p:spPr>
          <a:xfrm rot="5400000">
            <a:off x="4210854" y="5356180"/>
            <a:ext cx="57600" cy="1440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sz="1000" b="1"/>
          </a:p>
        </p:txBody>
      </p:sp>
      <p:cxnSp>
        <p:nvCxnSpPr>
          <p:cNvPr id="258" name="직선 연결선 257">
            <a:extLst>
              <a:ext uri="{FF2B5EF4-FFF2-40B4-BE49-F238E27FC236}">
                <a16:creationId xmlns:a16="http://schemas.microsoft.com/office/drawing/2014/main" id="{72A3C381-7933-4D58-89D9-133250446148}"/>
              </a:ext>
            </a:extLst>
          </p:cNvPr>
          <p:cNvCxnSpPr/>
          <p:nvPr/>
        </p:nvCxnSpPr>
        <p:spPr>
          <a:xfrm>
            <a:off x="4167654" y="5447397"/>
            <a:ext cx="0" cy="61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9" name="TextBox 258">
            <a:extLst>
              <a:ext uri="{FF2B5EF4-FFF2-40B4-BE49-F238E27FC236}">
                <a16:creationId xmlns:a16="http://schemas.microsoft.com/office/drawing/2014/main" id="{5153908A-F59E-457C-B633-1DCA6A67F7CE}"/>
              </a:ext>
            </a:extLst>
          </p:cNvPr>
          <p:cNvSpPr txBox="1"/>
          <p:nvPr/>
        </p:nvSpPr>
        <p:spPr>
          <a:xfrm>
            <a:off x="4605707" y="5973744"/>
            <a:ext cx="3717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**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0" name="왼쪽 대괄호 259">
            <a:extLst>
              <a:ext uri="{FF2B5EF4-FFF2-40B4-BE49-F238E27FC236}">
                <a16:creationId xmlns:a16="http://schemas.microsoft.com/office/drawing/2014/main" id="{573AE834-EBEE-4AA4-ACE4-C2ED2F320A3F}"/>
              </a:ext>
            </a:extLst>
          </p:cNvPr>
          <p:cNvSpPr/>
          <p:nvPr/>
        </p:nvSpPr>
        <p:spPr>
          <a:xfrm rot="5400000">
            <a:off x="4722352" y="6072331"/>
            <a:ext cx="57600" cy="1440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sz="1000" b="1"/>
          </a:p>
        </p:txBody>
      </p:sp>
      <p:sp>
        <p:nvSpPr>
          <p:cNvPr id="261" name="TextBox 260">
            <a:extLst>
              <a:ext uri="{FF2B5EF4-FFF2-40B4-BE49-F238E27FC236}">
                <a16:creationId xmlns:a16="http://schemas.microsoft.com/office/drawing/2014/main" id="{D614FFA4-A4B8-4DB3-9607-3EED4E1C65AE}"/>
              </a:ext>
            </a:extLst>
          </p:cNvPr>
          <p:cNvSpPr txBox="1"/>
          <p:nvPr/>
        </p:nvSpPr>
        <p:spPr>
          <a:xfrm>
            <a:off x="4650424" y="4711307"/>
            <a:ext cx="3717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**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2" name="왼쪽 대괄호 261">
            <a:extLst>
              <a:ext uri="{FF2B5EF4-FFF2-40B4-BE49-F238E27FC236}">
                <a16:creationId xmlns:a16="http://schemas.microsoft.com/office/drawing/2014/main" id="{8BACCDE9-30A3-49B0-8A74-08076A70696C}"/>
              </a:ext>
            </a:extLst>
          </p:cNvPr>
          <p:cNvSpPr/>
          <p:nvPr/>
        </p:nvSpPr>
        <p:spPr>
          <a:xfrm rot="5400000">
            <a:off x="4779393" y="4729419"/>
            <a:ext cx="57600" cy="3240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sz="1000" b="1"/>
          </a:p>
        </p:txBody>
      </p:sp>
      <p:cxnSp>
        <p:nvCxnSpPr>
          <p:cNvPr id="263" name="직선 연결선 262">
            <a:extLst>
              <a:ext uri="{FF2B5EF4-FFF2-40B4-BE49-F238E27FC236}">
                <a16:creationId xmlns:a16="http://schemas.microsoft.com/office/drawing/2014/main" id="{40A34B2A-22B5-4C0A-83E0-894EC48041F6}"/>
              </a:ext>
            </a:extLst>
          </p:cNvPr>
          <p:cNvCxnSpPr/>
          <p:nvPr/>
        </p:nvCxnSpPr>
        <p:spPr>
          <a:xfrm>
            <a:off x="4646193" y="4900124"/>
            <a:ext cx="0" cy="1620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4" name="직선 연결선 263">
            <a:extLst>
              <a:ext uri="{FF2B5EF4-FFF2-40B4-BE49-F238E27FC236}">
                <a16:creationId xmlns:a16="http://schemas.microsoft.com/office/drawing/2014/main" id="{EF1655C1-E322-46FB-AA95-4F150C4B66D7}"/>
              </a:ext>
            </a:extLst>
          </p:cNvPr>
          <p:cNvCxnSpPr/>
          <p:nvPr/>
        </p:nvCxnSpPr>
        <p:spPr>
          <a:xfrm>
            <a:off x="4679152" y="6163548"/>
            <a:ext cx="0" cy="324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5" name="TextBox 264">
            <a:extLst>
              <a:ext uri="{FF2B5EF4-FFF2-40B4-BE49-F238E27FC236}">
                <a16:creationId xmlns:a16="http://schemas.microsoft.com/office/drawing/2014/main" id="{06F9B535-5CE6-4ECF-BF35-650AE1B1266E}"/>
              </a:ext>
            </a:extLst>
          </p:cNvPr>
          <p:cNvSpPr txBox="1"/>
          <p:nvPr/>
        </p:nvSpPr>
        <p:spPr>
          <a:xfrm>
            <a:off x="4743468" y="4880688"/>
            <a:ext cx="3717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***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6" name="왼쪽 대괄호 265">
            <a:extLst>
              <a:ext uri="{FF2B5EF4-FFF2-40B4-BE49-F238E27FC236}">
                <a16:creationId xmlns:a16="http://schemas.microsoft.com/office/drawing/2014/main" id="{3835080D-0535-4F60-BC2C-86A9C179EECE}"/>
              </a:ext>
            </a:extLst>
          </p:cNvPr>
          <p:cNvSpPr/>
          <p:nvPr/>
        </p:nvSpPr>
        <p:spPr>
          <a:xfrm rot="5400000">
            <a:off x="4890849" y="4979275"/>
            <a:ext cx="57600" cy="1440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sz="1000" b="1"/>
          </a:p>
        </p:txBody>
      </p:sp>
      <p:cxnSp>
        <p:nvCxnSpPr>
          <p:cNvPr id="267" name="직선 연결선 266">
            <a:extLst>
              <a:ext uri="{FF2B5EF4-FFF2-40B4-BE49-F238E27FC236}">
                <a16:creationId xmlns:a16="http://schemas.microsoft.com/office/drawing/2014/main" id="{B71F1153-57C9-4D98-BFE4-AB4B0A951BED}"/>
              </a:ext>
            </a:extLst>
          </p:cNvPr>
          <p:cNvCxnSpPr/>
          <p:nvPr/>
        </p:nvCxnSpPr>
        <p:spPr>
          <a:xfrm>
            <a:off x="4847649" y="5070492"/>
            <a:ext cx="0" cy="1080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8" name="TextBox 267">
            <a:extLst>
              <a:ext uri="{FF2B5EF4-FFF2-40B4-BE49-F238E27FC236}">
                <a16:creationId xmlns:a16="http://schemas.microsoft.com/office/drawing/2014/main" id="{219F2FCE-1AF1-4BAE-A9E8-FA2E65830CDE}"/>
              </a:ext>
            </a:extLst>
          </p:cNvPr>
          <p:cNvSpPr txBox="1"/>
          <p:nvPr/>
        </p:nvSpPr>
        <p:spPr>
          <a:xfrm>
            <a:off x="5287269" y="6117760"/>
            <a:ext cx="3717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**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9" name="왼쪽 대괄호 268">
            <a:extLst>
              <a:ext uri="{FF2B5EF4-FFF2-40B4-BE49-F238E27FC236}">
                <a16:creationId xmlns:a16="http://schemas.microsoft.com/office/drawing/2014/main" id="{29C3925C-BDAD-4A27-9DB9-A739FB1431C6}"/>
              </a:ext>
            </a:extLst>
          </p:cNvPr>
          <p:cNvSpPr/>
          <p:nvPr/>
        </p:nvSpPr>
        <p:spPr>
          <a:xfrm rot="5400000">
            <a:off x="5411598" y="6216347"/>
            <a:ext cx="57600" cy="1440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sz="1000" b="1"/>
          </a:p>
        </p:txBody>
      </p:sp>
      <p:sp>
        <p:nvSpPr>
          <p:cNvPr id="270" name="TextBox 269">
            <a:extLst>
              <a:ext uri="{FF2B5EF4-FFF2-40B4-BE49-F238E27FC236}">
                <a16:creationId xmlns:a16="http://schemas.microsoft.com/office/drawing/2014/main" id="{B8BF92F3-247F-4A7C-AAC1-0F7BC9469B43}"/>
              </a:ext>
            </a:extLst>
          </p:cNvPr>
          <p:cNvSpPr txBox="1"/>
          <p:nvPr/>
        </p:nvSpPr>
        <p:spPr>
          <a:xfrm>
            <a:off x="5316618" y="5155388"/>
            <a:ext cx="3717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***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1" name="왼쪽 대괄호 270">
            <a:extLst>
              <a:ext uri="{FF2B5EF4-FFF2-40B4-BE49-F238E27FC236}">
                <a16:creationId xmlns:a16="http://schemas.microsoft.com/office/drawing/2014/main" id="{2A058773-6DC8-4486-8689-F4E8BD225985}"/>
              </a:ext>
            </a:extLst>
          </p:cNvPr>
          <p:cNvSpPr/>
          <p:nvPr/>
        </p:nvSpPr>
        <p:spPr>
          <a:xfrm rot="5400000">
            <a:off x="5468639" y="5173500"/>
            <a:ext cx="57600" cy="3240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sz="1000" b="1"/>
          </a:p>
        </p:txBody>
      </p:sp>
      <p:cxnSp>
        <p:nvCxnSpPr>
          <p:cNvPr id="272" name="직선 연결선 271">
            <a:extLst>
              <a:ext uri="{FF2B5EF4-FFF2-40B4-BE49-F238E27FC236}">
                <a16:creationId xmlns:a16="http://schemas.microsoft.com/office/drawing/2014/main" id="{34719C20-2D8D-468F-91B1-312E9491CB7D}"/>
              </a:ext>
            </a:extLst>
          </p:cNvPr>
          <p:cNvCxnSpPr/>
          <p:nvPr/>
        </p:nvCxnSpPr>
        <p:spPr>
          <a:xfrm>
            <a:off x="5335439" y="5344205"/>
            <a:ext cx="0" cy="115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3" name="직선 연결선 272">
            <a:extLst>
              <a:ext uri="{FF2B5EF4-FFF2-40B4-BE49-F238E27FC236}">
                <a16:creationId xmlns:a16="http://schemas.microsoft.com/office/drawing/2014/main" id="{17A5E223-FA0F-451D-B183-DED0C003D873}"/>
              </a:ext>
            </a:extLst>
          </p:cNvPr>
          <p:cNvCxnSpPr/>
          <p:nvPr/>
        </p:nvCxnSpPr>
        <p:spPr>
          <a:xfrm>
            <a:off x="5368398" y="6307564"/>
            <a:ext cx="0" cy="216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4" name="TextBox 273">
            <a:extLst>
              <a:ext uri="{FF2B5EF4-FFF2-40B4-BE49-F238E27FC236}">
                <a16:creationId xmlns:a16="http://schemas.microsoft.com/office/drawing/2014/main" id="{A808FA39-BB25-4324-936B-CE8FEC5E686D}"/>
              </a:ext>
            </a:extLst>
          </p:cNvPr>
          <p:cNvSpPr txBox="1"/>
          <p:nvPr/>
        </p:nvSpPr>
        <p:spPr>
          <a:xfrm>
            <a:off x="5463450" y="5338644"/>
            <a:ext cx="3717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**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5" name="왼쪽 대괄호 274">
            <a:extLst>
              <a:ext uri="{FF2B5EF4-FFF2-40B4-BE49-F238E27FC236}">
                <a16:creationId xmlns:a16="http://schemas.microsoft.com/office/drawing/2014/main" id="{A6DBCD45-966A-446C-9F20-31380A4F49D8}"/>
              </a:ext>
            </a:extLst>
          </p:cNvPr>
          <p:cNvSpPr/>
          <p:nvPr/>
        </p:nvSpPr>
        <p:spPr>
          <a:xfrm rot="5400000">
            <a:off x="5580095" y="5437231"/>
            <a:ext cx="57600" cy="1440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sz="1000" b="1"/>
          </a:p>
        </p:txBody>
      </p:sp>
      <p:cxnSp>
        <p:nvCxnSpPr>
          <p:cNvPr id="276" name="직선 연결선 275">
            <a:extLst>
              <a:ext uri="{FF2B5EF4-FFF2-40B4-BE49-F238E27FC236}">
                <a16:creationId xmlns:a16="http://schemas.microsoft.com/office/drawing/2014/main" id="{5D51561B-E102-4AD0-8A73-725F1AEDBC83}"/>
              </a:ext>
            </a:extLst>
          </p:cNvPr>
          <p:cNvCxnSpPr/>
          <p:nvPr/>
        </p:nvCxnSpPr>
        <p:spPr>
          <a:xfrm>
            <a:off x="5536895" y="5528448"/>
            <a:ext cx="0" cy="79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7" name="직선 연결선 276">
            <a:extLst>
              <a:ext uri="{FF2B5EF4-FFF2-40B4-BE49-F238E27FC236}">
                <a16:creationId xmlns:a16="http://schemas.microsoft.com/office/drawing/2014/main" id="{F86FB0B1-4D3B-497C-B4EC-493707C567BC}"/>
              </a:ext>
            </a:extLst>
          </p:cNvPr>
          <p:cNvCxnSpPr/>
          <p:nvPr/>
        </p:nvCxnSpPr>
        <p:spPr>
          <a:xfrm rot="5400000">
            <a:off x="2835472" y="6250118"/>
            <a:ext cx="0" cy="1728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8" name="직선 연결선 277">
            <a:extLst>
              <a:ext uri="{FF2B5EF4-FFF2-40B4-BE49-F238E27FC236}">
                <a16:creationId xmlns:a16="http://schemas.microsoft.com/office/drawing/2014/main" id="{60E80EF3-F58E-44FB-909D-86516F255561}"/>
              </a:ext>
            </a:extLst>
          </p:cNvPr>
          <p:cNvCxnSpPr/>
          <p:nvPr/>
        </p:nvCxnSpPr>
        <p:spPr>
          <a:xfrm rot="5400000">
            <a:off x="5254042" y="6592118"/>
            <a:ext cx="0" cy="1044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9" name="직선 연결선 278">
            <a:extLst>
              <a:ext uri="{FF2B5EF4-FFF2-40B4-BE49-F238E27FC236}">
                <a16:creationId xmlns:a16="http://schemas.microsoft.com/office/drawing/2014/main" id="{641DAE3A-570E-4EA3-9488-F70FC847A500}"/>
              </a:ext>
            </a:extLst>
          </p:cNvPr>
          <p:cNvCxnSpPr/>
          <p:nvPr/>
        </p:nvCxnSpPr>
        <p:spPr>
          <a:xfrm rot="5400000">
            <a:off x="4215757" y="6844118"/>
            <a:ext cx="0" cy="540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0" name="TextBox 279">
            <a:extLst>
              <a:ext uri="{FF2B5EF4-FFF2-40B4-BE49-F238E27FC236}">
                <a16:creationId xmlns:a16="http://schemas.microsoft.com/office/drawing/2014/main" id="{C58B82BD-D753-4499-8F70-0F78284167EF}"/>
              </a:ext>
            </a:extLst>
          </p:cNvPr>
          <p:cNvSpPr txBox="1"/>
          <p:nvPr/>
        </p:nvSpPr>
        <p:spPr>
          <a:xfrm>
            <a:off x="2419114" y="7118124"/>
            <a:ext cx="9421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poptosis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1" name="TextBox 280">
            <a:extLst>
              <a:ext uri="{FF2B5EF4-FFF2-40B4-BE49-F238E27FC236}">
                <a16:creationId xmlns:a16="http://schemas.microsoft.com/office/drawing/2014/main" id="{4E3E8034-52AB-4C6B-A08A-E20D0CDFF2F9}"/>
              </a:ext>
            </a:extLst>
          </p:cNvPr>
          <p:cNvSpPr txBox="1"/>
          <p:nvPr/>
        </p:nvSpPr>
        <p:spPr>
          <a:xfrm>
            <a:off x="4833936" y="7118124"/>
            <a:ext cx="94210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Cell cycle</a:t>
            </a:r>
          </a:p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rrest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2" name="TextBox 281">
            <a:extLst>
              <a:ext uri="{FF2B5EF4-FFF2-40B4-BE49-F238E27FC236}">
                <a16:creationId xmlns:a16="http://schemas.microsoft.com/office/drawing/2014/main" id="{B16D6FE9-536D-4BAC-AD0A-8699D2F7EBB7}"/>
              </a:ext>
            </a:extLst>
          </p:cNvPr>
          <p:cNvSpPr txBox="1"/>
          <p:nvPr/>
        </p:nvSpPr>
        <p:spPr>
          <a:xfrm>
            <a:off x="3748086" y="7118124"/>
            <a:ext cx="94210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DNA </a:t>
            </a:r>
          </a:p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repair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1229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48</TotalTime>
  <Words>440</Words>
  <Application>Microsoft Office PowerPoint</Application>
  <PresentationFormat>사용자 지정</PresentationFormat>
  <Paragraphs>117</Paragraphs>
  <Slides>7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7</vt:i4>
      </vt:variant>
    </vt:vector>
  </HeadingPairs>
  <TitlesOfParts>
    <vt:vector size="13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NAM</dc:creator>
  <cp:lastModifiedBy>angel</cp:lastModifiedBy>
  <cp:revision>24</cp:revision>
  <dcterms:created xsi:type="dcterms:W3CDTF">2018-06-19T11:52:55Z</dcterms:created>
  <dcterms:modified xsi:type="dcterms:W3CDTF">2019-05-26T05:22:14Z</dcterms:modified>
</cp:coreProperties>
</file>